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08813" cy="120380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AC021-3096-4315-A376-2FADD46881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D662A-7FB7-4A77-B2F3-D57790E78F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78363-85D2-4C15-879A-95E53FAFC6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2AF61-9C35-4372-9C28-CE497CA31D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7A0B3-3AD3-4A28-8A70-F49F7D1AA4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AD4B6-74F8-4DAD-A8D9-50464A2108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D04DC-9F07-4E37-AD41-BE19E01ECA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D5A58-5FC1-4EED-846D-9C7D63792E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FB862-D244-4A55-93E4-48FC61CE05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A6336-4091-4B8C-9DFD-2FBC66590F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A5498-5933-4437-A329-C0EA73C2E6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8A8D0-79C2-42EB-B411-375381B410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3593FA-1AA0-46E0-A035-6464DB06B04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40840" y="561240"/>
            <a:ext cx="5187960" cy="9047160"/>
            <a:chOff x="240840" y="561240"/>
            <a:chExt cx="5187960" cy="9047160"/>
          </a:xfrm>
        </p:grpSpPr>
        <p:grpSp>
          <p:nvGrpSpPr>
            <p:cNvPr id="42" name=""/>
            <p:cNvGrpSpPr/>
            <p:nvPr/>
          </p:nvGrpSpPr>
          <p:grpSpPr>
            <a:xfrm>
              <a:off x="240840" y="576000"/>
              <a:ext cx="4089960" cy="6642000"/>
              <a:chOff x="240840" y="576000"/>
              <a:chExt cx="4089960" cy="6642000"/>
            </a:xfrm>
          </p:grpSpPr>
          <p:sp>
            <p:nvSpPr>
              <p:cNvPr id="43" name=""/>
              <p:cNvSpPr/>
              <p:nvPr/>
            </p:nvSpPr>
            <p:spPr>
              <a:xfrm>
                <a:off x="240840" y="253116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V="1">
                <a:off x="493920" y="1486440"/>
                <a:ext cx="0" cy="1044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493920" y="148644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V="1">
                <a:off x="643680" y="141192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643680" y="141192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V="1">
                <a:off x="793080" y="1038600"/>
                <a:ext cx="0" cy="3726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793080" y="103896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972000" y="933840"/>
                <a:ext cx="0" cy="104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972000" y="934200"/>
                <a:ext cx="32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1300320" y="874800"/>
                <a:ext cx="0" cy="59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300320" y="87480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1389960" y="78480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389960" y="78516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1643760" y="69516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1643760" y="69552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1658520" y="63576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1658520" y="635760"/>
                <a:ext cx="26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 flipV="1">
                <a:off x="1927080" y="5907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1927080" y="591120"/>
                <a:ext cx="35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 flipV="1">
                <a:off x="2285280" y="57600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285280" y="576000"/>
                <a:ext cx="46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285280" y="591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285280" y="621000"/>
                <a:ext cx="731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927080" y="63576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1927080" y="680760"/>
                <a:ext cx="46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V="1">
                <a:off x="2390400" y="66564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390400" y="665640"/>
                <a:ext cx="46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390400" y="6807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390400" y="69552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658520" y="69552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1658520" y="78516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V="1">
                <a:off x="2241000" y="73980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2241000" y="740160"/>
                <a:ext cx="790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241000" y="7851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241000" y="815040"/>
                <a:ext cx="5223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V="1">
                <a:off x="2763360" y="7848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763360" y="78516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763360" y="81504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763360" y="82980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1643760" y="78516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1643760" y="889560"/>
                <a:ext cx="29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1942560" y="8748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1942560" y="874800"/>
                <a:ext cx="4478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942560" y="8895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1942560" y="919440"/>
                <a:ext cx="5522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1389960" y="87480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1389960" y="979200"/>
                <a:ext cx="432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 flipV="1">
                <a:off x="1822680" y="9489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1822680" y="949320"/>
                <a:ext cx="11343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1822680" y="9792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1822680" y="993960"/>
                <a:ext cx="26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300320" y="934200"/>
                <a:ext cx="0" cy="104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300320" y="1038960"/>
                <a:ext cx="11044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972000" y="103896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972000" y="1158120"/>
                <a:ext cx="4478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 flipV="1">
                <a:off x="1419840" y="108360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419840" y="1083600"/>
                <a:ext cx="925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419840" y="115812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419840" y="120312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 flipV="1">
                <a:off x="1539360" y="112824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539360" y="1128240"/>
                <a:ext cx="537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1539360" y="120312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1539360" y="124776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1613880" y="12027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1613880" y="1203120"/>
                <a:ext cx="417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V="1">
                <a:off x="2032200" y="115776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2032200" y="1158120"/>
                <a:ext cx="835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2032200" y="1203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2032200" y="123300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V="1">
                <a:off x="2241000" y="12027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2241000" y="12031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2241000" y="12330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2241000" y="1262880"/>
                <a:ext cx="895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3137040" y="12477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3137040" y="124776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3137040" y="126288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3137040" y="1292400"/>
                <a:ext cx="223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1613880" y="124776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1613880" y="1337400"/>
                <a:ext cx="1402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793080" y="1411920"/>
                <a:ext cx="0" cy="596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793080" y="2008800"/>
                <a:ext cx="447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 flipV="1">
                <a:off x="1240560" y="188964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1240560" y="1889640"/>
                <a:ext cx="1358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 flipV="1">
                <a:off x="2599200" y="1725480"/>
                <a:ext cx="0" cy="16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2599200" y="172548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 flipV="1">
                <a:off x="2718720" y="1471320"/>
                <a:ext cx="0" cy="253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718720" y="147168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3301200" y="136692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301200" y="1367280"/>
                <a:ext cx="746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301200" y="147168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301200" y="154620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 flipV="1">
                <a:off x="3331080" y="147168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331080" y="1471680"/>
                <a:ext cx="26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 flipV="1">
                <a:off x="3599640" y="1441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599640" y="1441800"/>
                <a:ext cx="22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flipV="1">
                <a:off x="3823560" y="14115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823560" y="1411920"/>
                <a:ext cx="13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823560" y="14418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3823560" y="1456560"/>
                <a:ext cx="13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599640" y="14716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3599640" y="1501560"/>
                <a:ext cx="342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3331080" y="154620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3331080" y="1621080"/>
                <a:ext cx="46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 flipV="1">
                <a:off x="3793680" y="154620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3793680" y="154620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3793680" y="162108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3793680" y="169560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 flipV="1">
                <a:off x="3898080" y="165024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898080" y="165060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 flipV="1">
                <a:off x="4062240" y="16056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4062240" y="160596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 flipV="1">
                <a:off x="4106880" y="15757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4106880" y="1576080"/>
                <a:ext cx="22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4106880" y="16059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4106880" y="162108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4062240" y="165060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4062240" y="16956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 flipV="1">
                <a:off x="4136760" y="1665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4136760" y="16657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4136760" y="16956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4136760" y="17103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898080" y="169560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898080" y="175536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2718720" y="1725480"/>
                <a:ext cx="0" cy="22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2718720" y="1949400"/>
                <a:ext cx="342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 flipV="1">
                <a:off x="3061800" y="188964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3061800" y="1889640"/>
                <a:ext cx="477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 flipV="1">
                <a:off x="3539880" y="184428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3539880" y="184464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V="1">
                <a:off x="3644280" y="18144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3644280" y="181476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 flipV="1">
                <a:off x="3704040" y="18000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3704040" y="18000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3704040" y="18147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704040" y="18298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3644280" y="1844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3644280" y="187452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3539880" y="18896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3539880" y="193428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 flipV="1">
                <a:off x="3614040" y="19195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3614040" y="191952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3614040" y="19342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3614040" y="19641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3061800" y="1949400"/>
                <a:ext cx="0" cy="59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3061800" y="20088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2599200" y="1889640"/>
                <a:ext cx="0" cy="1486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2599200" y="20386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240560" y="2008800"/>
                <a:ext cx="0" cy="104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240560" y="2113560"/>
                <a:ext cx="985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2226240" y="20833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2226240" y="2083680"/>
                <a:ext cx="447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2226240" y="21135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2226240" y="2128320"/>
                <a:ext cx="611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643680" y="1486440"/>
                <a:ext cx="0" cy="701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643680" y="2188080"/>
                <a:ext cx="2627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 flipV="1">
                <a:off x="3271320" y="21729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3271320" y="217296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3271320" y="21880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3271320" y="221796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 flipV="1">
                <a:off x="493920" y="2277360"/>
                <a:ext cx="0" cy="253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93920" y="2277720"/>
                <a:ext cx="1314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 flipV="1">
                <a:off x="1807920" y="22474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1807920" y="2247840"/>
                <a:ext cx="761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1807920" y="22777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1807920" y="2292480"/>
                <a:ext cx="895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493920" y="2531160"/>
                <a:ext cx="0" cy="46868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493920" y="7218000"/>
                <a:ext cx="701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V="1">
                <a:off x="1195920" y="5874480"/>
                <a:ext cx="0" cy="1343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1195920" y="587484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V="1">
                <a:off x="1225800" y="3530880"/>
                <a:ext cx="0" cy="23432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1225800" y="353124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V="1">
                <a:off x="1330200" y="2456280"/>
                <a:ext cx="0" cy="10746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1330200" y="245664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V="1">
                <a:off x="1479600" y="235188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1479600" y="235224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V="1">
                <a:off x="1673640" y="233748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673640" y="2337480"/>
                <a:ext cx="22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673640" y="23522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1673640" y="2382120"/>
                <a:ext cx="35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1479600" y="245664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1479600" y="254628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 flipV="1">
                <a:off x="1658520" y="248652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1658520" y="2486520"/>
                <a:ext cx="388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 flipV="1">
                <a:off x="2046600" y="244152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2046600" y="244188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 flipV="1">
                <a:off x="2062080" y="24267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2062080" y="242676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2062080" y="244188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2062080" y="245664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2046600" y="248652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2046600" y="253116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 flipV="1">
                <a:off x="2151000" y="250128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2151000" y="250164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2151000" y="25311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2151000" y="254628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1658520" y="254628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1658520" y="2606040"/>
                <a:ext cx="32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 flipV="1">
                <a:off x="1986840" y="25909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1986840" y="259092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1986840" y="26060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3" name=""/>
            <p:cNvGrpSpPr/>
            <p:nvPr/>
          </p:nvGrpSpPr>
          <p:grpSpPr>
            <a:xfrm>
              <a:off x="1330200" y="2636280"/>
              <a:ext cx="1552320" cy="3208680"/>
              <a:chOff x="1330200" y="2636280"/>
              <a:chExt cx="1552320" cy="3208680"/>
            </a:xfrm>
          </p:grpSpPr>
          <p:sp>
            <p:nvSpPr>
              <p:cNvPr id="244" name=""/>
              <p:cNvSpPr/>
              <p:nvPr/>
            </p:nvSpPr>
            <p:spPr>
              <a:xfrm>
                <a:off x="1986840" y="263628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1330200" y="3531240"/>
                <a:ext cx="0" cy="9849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1330200" y="451656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 flipV="1">
                <a:off x="1389960" y="2979000"/>
                <a:ext cx="0" cy="1537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1389960" y="297900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 flipV="1">
                <a:off x="1584000" y="2829960"/>
                <a:ext cx="0" cy="1486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1584000" y="283032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 flipV="1">
                <a:off x="1598400" y="271044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1598400" y="271044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 flipV="1">
                <a:off x="1688400" y="26802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1688400" y="2680560"/>
                <a:ext cx="209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1688400" y="2710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1688400" y="274032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 flipV="1">
                <a:off x="1942200" y="27100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1942200" y="2710440"/>
                <a:ext cx="26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1942200" y="27403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1942200" y="275508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1598400" y="283032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1598400" y="294912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 flipV="1">
                <a:off x="1688400" y="281484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1688400" y="281484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 flipV="1">
                <a:off x="1748160" y="280044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1748160" y="280044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1748160" y="28148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1748160" y="2844720"/>
                <a:ext cx="417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1688400" y="294912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1688400" y="306864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 flipV="1">
                <a:off x="1732680" y="30240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1732680" y="302436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 flipV="1">
                <a:off x="1807920" y="297864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1807920" y="2979000"/>
                <a:ext cx="22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 flipV="1">
                <a:off x="2031840" y="29340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2031840" y="293436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 flipV="1">
                <a:off x="2061720" y="2904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2061720" y="2904480"/>
                <a:ext cx="29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 flipV="1">
                <a:off x="2090880" y="28893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2090880" y="28893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2090880" y="290448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2090880" y="291924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2061720" y="2934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2061720" y="296460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2031840" y="29790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2031840" y="300888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1807920" y="30243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>
                <a:off x="1807920" y="306864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 flipV="1">
                <a:off x="1897560" y="305424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1897560" y="305424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>
                <a:off x="1897560" y="3068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>
                <a:off x="1897560" y="309852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1732680" y="306864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>
                <a:off x="1732680" y="3128760"/>
                <a:ext cx="791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>
                <a:off x="1584000" y="2979000"/>
                <a:ext cx="0" cy="19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>
                <a:off x="1584000" y="3173040"/>
                <a:ext cx="26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1389960" y="4516560"/>
                <a:ext cx="0" cy="1328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1389960" y="584496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 flipV="1">
                <a:off x="1434240" y="5009400"/>
                <a:ext cx="0" cy="835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1434240" y="500940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 flipV="1">
                <a:off x="1479600" y="4635720"/>
                <a:ext cx="0" cy="3733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1479600" y="463608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 flipV="1">
                <a:off x="1539360" y="4187880"/>
                <a:ext cx="0" cy="4478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1539360" y="41878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 flipV="1">
                <a:off x="1539360" y="3919320"/>
                <a:ext cx="0" cy="268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1539360" y="391968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 flipV="1">
                <a:off x="1613880" y="379980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1613880" y="379980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 flipV="1">
                <a:off x="1703520" y="368100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1703520" y="3681000"/>
                <a:ext cx="59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 flipV="1">
                <a:off x="1762560" y="3516840"/>
                <a:ext cx="0" cy="16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1762560" y="351684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 flipV="1">
                <a:off x="1822680" y="341208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1822680" y="341244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 flipV="1">
                <a:off x="1912320" y="333720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1912320" y="33372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 flipV="1">
                <a:off x="1986840" y="326304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>
                <a:off x="1986840" y="326304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 flipV="1">
                <a:off x="1986840" y="3232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1986840" y="323280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 flipV="1">
                <a:off x="2016720" y="32184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2016720" y="321840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2016720" y="32328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2016720" y="326304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1986840" y="32630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1986840" y="330732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1986840" y="333720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1986840" y="341244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 flipV="1">
                <a:off x="2046600" y="336672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2046600" y="336708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 flipV="1">
                <a:off x="2106360" y="33368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2106360" y="333720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2106360" y="336708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2106360" y="338256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2046600" y="341244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2046600" y="344160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 flipV="1">
                <a:off x="2061720" y="34272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2061720" y="342720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2061720" y="34416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2061720" y="347148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1912320" y="341244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1912320" y="3516840"/>
                <a:ext cx="298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1822680" y="3516840"/>
                <a:ext cx="0" cy="88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1822680" y="360576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 flipV="1">
                <a:off x="1897560" y="3546720"/>
                <a:ext cx="0" cy="59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1897560" y="354672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1897560" y="360576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1897560" y="365112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 flipV="1">
                <a:off x="2031840" y="36208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2031840" y="362124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 flipV="1">
                <a:off x="2046600" y="35910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2046600" y="359136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2046600" y="362124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2046600" y="363564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2031840" y="3651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2031840" y="3681000"/>
                <a:ext cx="8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1762560" y="3681000"/>
                <a:ext cx="0" cy="16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1762560" y="3845160"/>
                <a:ext cx="104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 flipV="1">
                <a:off x="1867680" y="378540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1867680" y="3785400"/>
                <a:ext cx="148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 flipV="1">
                <a:off x="2016720" y="37404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2016720" y="374076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 flipV="1">
                <a:off x="2106360" y="372528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2106360" y="372528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2106360" y="37407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2106360" y="377064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2016720" y="37854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2016720" y="382968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 flipV="1">
                <a:off x="2076480" y="3799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2076480" y="37998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2076480" y="382968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>
                <a:off x="2076480" y="38451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>
                <a:off x="1867680" y="384516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1867680" y="3904920"/>
                <a:ext cx="37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 flipV="1">
                <a:off x="2240640" y="388980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2240640" y="38898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2240640" y="39049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2240640" y="39348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1703520" y="3799800"/>
                <a:ext cx="0" cy="179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1703520" y="3979440"/>
                <a:ext cx="477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1613880" y="391968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1613880" y="40392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 flipV="1">
                <a:off x="1688400" y="40089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1688400" y="4009320"/>
                <a:ext cx="1194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1688400" y="40392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1688400" y="4053960"/>
                <a:ext cx="313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1539360" y="4187880"/>
                <a:ext cx="0" cy="3135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>
                <a:off x="1539360" y="450180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 flipV="1">
                <a:off x="1792440" y="442728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1792440" y="442728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 flipV="1">
                <a:off x="1807920" y="433728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1807920" y="433764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 flipV="1">
                <a:off x="1837800" y="423288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1837800" y="423324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 flipV="1">
                <a:off x="1882440" y="411372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1882440" y="411372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 flipV="1">
                <a:off x="2031840" y="40989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2031840" y="40989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2031840" y="41137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2031840" y="41436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1882440" y="423324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1882440" y="433764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 flipV="1">
                <a:off x="1897560" y="427788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1897560" y="427788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 flipV="1">
                <a:off x="1912320" y="421812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1912320" y="421812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 flipV="1">
                <a:off x="1926720" y="41875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1926720" y="418788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1926720" y="421812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1926720" y="426312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 flipV="1">
                <a:off x="1942200" y="421776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1942200" y="4218120"/>
                <a:ext cx="612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1942200" y="4263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1942200" y="429300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 flipV="1">
                <a:off x="1956600" y="42627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1956600" y="426312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1956600" y="42930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1956600" y="430776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1912320" y="427788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1912320" y="435204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1897560" y="433764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1897560" y="4397400"/>
                <a:ext cx="8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1837800" y="433764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1837800" y="4457160"/>
                <a:ext cx="118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 flipV="1">
                <a:off x="1956600" y="44269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1956600" y="442728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1956600" y="44571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1956600" y="447192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1807920" y="4427280"/>
                <a:ext cx="0" cy="88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1807920" y="451656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1792440" y="450180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1792440" y="457632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 flipV="1">
                <a:off x="1867680" y="45615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1867680" y="4561560"/>
                <a:ext cx="223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1867680" y="45763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1867680" y="4606200"/>
                <a:ext cx="8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1539360" y="4636080"/>
                <a:ext cx="0" cy="4924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1539360" y="512856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 flipV="1">
                <a:off x="1643760" y="499428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1643760" y="499428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 flipV="1">
                <a:off x="1673640" y="4830120"/>
                <a:ext cx="0" cy="16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1673640" y="4830120"/>
                <a:ext cx="59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 flipV="1">
                <a:off x="1732680" y="471060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4" name=""/>
            <p:cNvGrpSpPr/>
            <p:nvPr/>
          </p:nvGrpSpPr>
          <p:grpSpPr>
            <a:xfrm>
              <a:off x="1434600" y="4651560"/>
              <a:ext cx="1402560" cy="2178000"/>
              <a:chOff x="1434600" y="4651560"/>
              <a:chExt cx="1402560" cy="2178000"/>
            </a:xfrm>
          </p:grpSpPr>
          <p:sp>
            <p:nvSpPr>
              <p:cNvPr id="445" name=""/>
              <p:cNvSpPr/>
              <p:nvPr/>
            </p:nvSpPr>
            <p:spPr>
              <a:xfrm>
                <a:off x="1733040" y="471060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"/>
              <p:cNvSpPr/>
              <p:nvPr/>
            </p:nvSpPr>
            <p:spPr>
              <a:xfrm flipV="1">
                <a:off x="1778040" y="46656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"/>
              <p:cNvSpPr/>
              <p:nvPr/>
            </p:nvSpPr>
            <p:spPr>
              <a:xfrm>
                <a:off x="1778040" y="466596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"/>
              <p:cNvSpPr/>
              <p:nvPr/>
            </p:nvSpPr>
            <p:spPr>
              <a:xfrm flipV="1">
                <a:off x="1837800" y="46515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"/>
              <p:cNvSpPr/>
              <p:nvPr/>
            </p:nvSpPr>
            <p:spPr>
              <a:xfrm>
                <a:off x="1837800" y="465156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>
                <a:off x="1837800" y="46659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>
                <a:off x="1837800" y="468072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1778040" y="471060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>
                <a:off x="1778040" y="47556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"/>
              <p:cNvSpPr/>
              <p:nvPr/>
            </p:nvSpPr>
            <p:spPr>
              <a:xfrm flipV="1">
                <a:off x="1852560" y="4725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"/>
              <p:cNvSpPr/>
              <p:nvPr/>
            </p:nvSpPr>
            <p:spPr>
              <a:xfrm>
                <a:off x="1852560" y="472572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"/>
              <p:cNvSpPr/>
              <p:nvPr/>
            </p:nvSpPr>
            <p:spPr>
              <a:xfrm>
                <a:off x="1852560" y="47556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"/>
              <p:cNvSpPr/>
              <p:nvPr/>
            </p:nvSpPr>
            <p:spPr>
              <a:xfrm>
                <a:off x="1852560" y="477036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"/>
              <p:cNvSpPr/>
              <p:nvPr/>
            </p:nvSpPr>
            <p:spPr>
              <a:xfrm>
                <a:off x="1733040" y="483012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"/>
              <p:cNvSpPr/>
              <p:nvPr/>
            </p:nvSpPr>
            <p:spPr>
              <a:xfrm>
                <a:off x="1733040" y="494964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"/>
              <p:cNvSpPr/>
              <p:nvPr/>
            </p:nvSpPr>
            <p:spPr>
              <a:xfrm flipV="1">
                <a:off x="1822680" y="488988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"/>
              <p:cNvSpPr/>
              <p:nvPr/>
            </p:nvSpPr>
            <p:spPr>
              <a:xfrm>
                <a:off x="1822680" y="488988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"/>
              <p:cNvSpPr/>
              <p:nvPr/>
            </p:nvSpPr>
            <p:spPr>
              <a:xfrm flipV="1">
                <a:off x="1972080" y="4859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>
                <a:off x="1972080" y="48600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"/>
              <p:cNvSpPr/>
              <p:nvPr/>
            </p:nvSpPr>
            <p:spPr>
              <a:xfrm flipV="1">
                <a:off x="2046600" y="48297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"/>
              <p:cNvSpPr/>
              <p:nvPr/>
            </p:nvSpPr>
            <p:spPr>
              <a:xfrm>
                <a:off x="2046600" y="483012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"/>
              <p:cNvSpPr/>
              <p:nvPr/>
            </p:nvSpPr>
            <p:spPr>
              <a:xfrm flipV="1">
                <a:off x="2166120" y="48153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"/>
              <p:cNvSpPr/>
              <p:nvPr/>
            </p:nvSpPr>
            <p:spPr>
              <a:xfrm>
                <a:off x="2166120" y="48153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"/>
              <p:cNvSpPr/>
              <p:nvPr/>
            </p:nvSpPr>
            <p:spPr>
              <a:xfrm>
                <a:off x="2166120" y="4830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"/>
              <p:cNvSpPr/>
              <p:nvPr/>
            </p:nvSpPr>
            <p:spPr>
              <a:xfrm>
                <a:off x="2166120" y="48600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"/>
              <p:cNvSpPr/>
              <p:nvPr/>
            </p:nvSpPr>
            <p:spPr>
              <a:xfrm>
                <a:off x="2046600" y="48600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"/>
              <p:cNvSpPr/>
              <p:nvPr/>
            </p:nvSpPr>
            <p:spPr>
              <a:xfrm>
                <a:off x="2046600" y="488988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"/>
              <p:cNvSpPr/>
              <p:nvPr/>
            </p:nvSpPr>
            <p:spPr>
              <a:xfrm>
                <a:off x="1972080" y="488988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1972080" y="4934520"/>
                <a:ext cx="4024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"/>
              <p:cNvSpPr/>
              <p:nvPr/>
            </p:nvSpPr>
            <p:spPr>
              <a:xfrm>
                <a:off x="1822680" y="49496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"/>
              <p:cNvSpPr/>
              <p:nvPr/>
            </p:nvSpPr>
            <p:spPr>
              <a:xfrm>
                <a:off x="1822680" y="499428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"/>
              <p:cNvSpPr/>
              <p:nvPr/>
            </p:nvSpPr>
            <p:spPr>
              <a:xfrm flipV="1">
                <a:off x="1897560" y="49795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"/>
              <p:cNvSpPr/>
              <p:nvPr/>
            </p:nvSpPr>
            <p:spPr>
              <a:xfrm>
                <a:off x="1897560" y="497952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"/>
              <p:cNvSpPr/>
              <p:nvPr/>
            </p:nvSpPr>
            <p:spPr>
              <a:xfrm>
                <a:off x="1897560" y="49942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"/>
              <p:cNvSpPr/>
              <p:nvPr/>
            </p:nvSpPr>
            <p:spPr>
              <a:xfrm>
                <a:off x="1897560" y="502416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"/>
              <p:cNvSpPr/>
              <p:nvPr/>
            </p:nvSpPr>
            <p:spPr>
              <a:xfrm>
                <a:off x="1673640" y="4994280"/>
                <a:ext cx="0" cy="20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"/>
              <p:cNvSpPr/>
              <p:nvPr/>
            </p:nvSpPr>
            <p:spPr>
              <a:xfrm>
                <a:off x="1673640" y="5203800"/>
                <a:ext cx="28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"/>
              <p:cNvSpPr/>
              <p:nvPr/>
            </p:nvSpPr>
            <p:spPr>
              <a:xfrm flipV="1">
                <a:off x="1956960" y="514368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1956960" y="5143680"/>
                <a:ext cx="209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"/>
              <p:cNvSpPr/>
              <p:nvPr/>
            </p:nvSpPr>
            <p:spPr>
              <a:xfrm flipV="1">
                <a:off x="2166120" y="5113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5" name=""/>
              <p:cNvSpPr/>
              <p:nvPr/>
            </p:nvSpPr>
            <p:spPr>
              <a:xfrm>
                <a:off x="2166120" y="51138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6" name=""/>
              <p:cNvSpPr/>
              <p:nvPr/>
            </p:nvSpPr>
            <p:spPr>
              <a:xfrm flipV="1">
                <a:off x="2240640" y="50835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7" name=""/>
              <p:cNvSpPr/>
              <p:nvPr/>
            </p:nvSpPr>
            <p:spPr>
              <a:xfrm>
                <a:off x="2240640" y="508392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8" name=""/>
              <p:cNvSpPr/>
              <p:nvPr/>
            </p:nvSpPr>
            <p:spPr>
              <a:xfrm flipV="1">
                <a:off x="2285280" y="506880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"/>
              <p:cNvSpPr/>
              <p:nvPr/>
            </p:nvSpPr>
            <p:spPr>
              <a:xfrm>
                <a:off x="2285280" y="506880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"/>
              <p:cNvSpPr/>
              <p:nvPr/>
            </p:nvSpPr>
            <p:spPr>
              <a:xfrm>
                <a:off x="2285280" y="50839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"/>
              <p:cNvSpPr/>
              <p:nvPr/>
            </p:nvSpPr>
            <p:spPr>
              <a:xfrm>
                <a:off x="2285280" y="509868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"/>
              <p:cNvSpPr/>
              <p:nvPr/>
            </p:nvSpPr>
            <p:spPr>
              <a:xfrm>
                <a:off x="2240640" y="51138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>
                <a:off x="2240640" y="514368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4" name=""/>
              <p:cNvSpPr/>
              <p:nvPr/>
            </p:nvSpPr>
            <p:spPr>
              <a:xfrm>
                <a:off x="2166120" y="514368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5" name=""/>
              <p:cNvSpPr/>
              <p:nvPr/>
            </p:nvSpPr>
            <p:spPr>
              <a:xfrm>
                <a:off x="2166120" y="5188320"/>
                <a:ext cx="641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"/>
              <p:cNvSpPr/>
              <p:nvPr/>
            </p:nvSpPr>
            <p:spPr>
              <a:xfrm>
                <a:off x="1956960" y="52038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"/>
              <p:cNvSpPr/>
              <p:nvPr/>
            </p:nvSpPr>
            <p:spPr>
              <a:xfrm>
                <a:off x="1956960" y="524808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"/>
              <p:cNvSpPr/>
              <p:nvPr/>
            </p:nvSpPr>
            <p:spPr>
              <a:xfrm flipV="1">
                <a:off x="2031840" y="52329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"/>
              <p:cNvSpPr/>
              <p:nvPr/>
            </p:nvSpPr>
            <p:spPr>
              <a:xfrm>
                <a:off x="2031840" y="5232960"/>
                <a:ext cx="28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0" name=""/>
              <p:cNvSpPr/>
              <p:nvPr/>
            </p:nvSpPr>
            <p:spPr>
              <a:xfrm>
                <a:off x="2031840" y="52480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1" name=""/>
              <p:cNvSpPr/>
              <p:nvPr/>
            </p:nvSpPr>
            <p:spPr>
              <a:xfrm>
                <a:off x="2031840" y="527796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2" name=""/>
              <p:cNvSpPr/>
              <p:nvPr/>
            </p:nvSpPr>
            <p:spPr>
              <a:xfrm>
                <a:off x="1643760" y="5128560"/>
                <a:ext cx="0" cy="179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3" name=""/>
              <p:cNvSpPr/>
              <p:nvPr/>
            </p:nvSpPr>
            <p:spPr>
              <a:xfrm>
                <a:off x="1643760" y="5307840"/>
                <a:ext cx="566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4" name=""/>
              <p:cNvSpPr/>
              <p:nvPr/>
            </p:nvSpPr>
            <p:spPr>
              <a:xfrm>
                <a:off x="1479600" y="5009400"/>
                <a:ext cx="0" cy="3873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"/>
              <p:cNvSpPr/>
              <p:nvPr/>
            </p:nvSpPr>
            <p:spPr>
              <a:xfrm>
                <a:off x="1479600" y="539712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6" name=""/>
              <p:cNvSpPr/>
              <p:nvPr/>
            </p:nvSpPr>
            <p:spPr>
              <a:xfrm flipV="1">
                <a:off x="1524240" y="535212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7" name=""/>
              <p:cNvSpPr/>
              <p:nvPr/>
            </p:nvSpPr>
            <p:spPr>
              <a:xfrm>
                <a:off x="1524240" y="5352480"/>
                <a:ext cx="417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8" name=""/>
              <p:cNvSpPr/>
              <p:nvPr/>
            </p:nvSpPr>
            <p:spPr>
              <a:xfrm>
                <a:off x="1524240" y="53971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9" name=""/>
              <p:cNvSpPr/>
              <p:nvPr/>
            </p:nvSpPr>
            <p:spPr>
              <a:xfrm>
                <a:off x="1524240" y="541224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"/>
              <p:cNvSpPr/>
              <p:nvPr/>
            </p:nvSpPr>
            <p:spPr>
              <a:xfrm flipV="1">
                <a:off x="1733040" y="53971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"/>
              <p:cNvSpPr/>
              <p:nvPr/>
            </p:nvSpPr>
            <p:spPr>
              <a:xfrm>
                <a:off x="1733040" y="5397120"/>
                <a:ext cx="328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2" name=""/>
              <p:cNvSpPr/>
              <p:nvPr/>
            </p:nvSpPr>
            <p:spPr>
              <a:xfrm>
                <a:off x="1733040" y="54122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3" name=""/>
              <p:cNvSpPr/>
              <p:nvPr/>
            </p:nvSpPr>
            <p:spPr>
              <a:xfrm>
                <a:off x="1733040" y="5442120"/>
                <a:ext cx="35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4" name=""/>
              <p:cNvSpPr/>
              <p:nvPr/>
            </p:nvSpPr>
            <p:spPr>
              <a:xfrm>
                <a:off x="1434600" y="5844960"/>
                <a:ext cx="0" cy="791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5" name=""/>
              <p:cNvSpPr/>
              <p:nvPr/>
            </p:nvSpPr>
            <p:spPr>
              <a:xfrm>
                <a:off x="1434600" y="663624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6" name=""/>
              <p:cNvSpPr/>
              <p:nvPr/>
            </p:nvSpPr>
            <p:spPr>
              <a:xfrm flipV="1">
                <a:off x="1434600" y="6292800"/>
                <a:ext cx="0" cy="3434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7" name=""/>
              <p:cNvSpPr/>
              <p:nvPr/>
            </p:nvSpPr>
            <p:spPr>
              <a:xfrm>
                <a:off x="1434600" y="629280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8" name=""/>
              <p:cNvSpPr/>
              <p:nvPr/>
            </p:nvSpPr>
            <p:spPr>
              <a:xfrm flipV="1">
                <a:off x="1464480" y="6068880"/>
                <a:ext cx="0" cy="22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1464480" y="606888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0" name=""/>
              <p:cNvSpPr/>
              <p:nvPr/>
            </p:nvSpPr>
            <p:spPr>
              <a:xfrm flipV="1">
                <a:off x="1494360" y="594936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1" name=""/>
              <p:cNvSpPr/>
              <p:nvPr/>
            </p:nvSpPr>
            <p:spPr>
              <a:xfrm>
                <a:off x="1494360" y="594936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"/>
              <p:cNvSpPr/>
              <p:nvPr/>
            </p:nvSpPr>
            <p:spPr>
              <a:xfrm flipV="1">
                <a:off x="1584000" y="581508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"/>
              <p:cNvSpPr/>
              <p:nvPr/>
            </p:nvSpPr>
            <p:spPr>
              <a:xfrm>
                <a:off x="1584000" y="581508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"/>
              <p:cNvSpPr/>
              <p:nvPr/>
            </p:nvSpPr>
            <p:spPr>
              <a:xfrm flipV="1">
                <a:off x="1778040" y="5725440"/>
                <a:ext cx="0" cy="88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120" bIns="42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"/>
              <p:cNvSpPr/>
              <p:nvPr/>
            </p:nvSpPr>
            <p:spPr>
              <a:xfrm>
                <a:off x="1778040" y="5725800"/>
                <a:ext cx="14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"/>
              <p:cNvSpPr/>
              <p:nvPr/>
            </p:nvSpPr>
            <p:spPr>
              <a:xfrm flipV="1">
                <a:off x="1792800" y="563580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"/>
              <p:cNvSpPr/>
              <p:nvPr/>
            </p:nvSpPr>
            <p:spPr>
              <a:xfrm>
                <a:off x="1792800" y="563616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"/>
              <p:cNvSpPr/>
              <p:nvPr/>
            </p:nvSpPr>
            <p:spPr>
              <a:xfrm flipV="1">
                <a:off x="1822680" y="556200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9" name=""/>
              <p:cNvSpPr/>
              <p:nvPr/>
            </p:nvSpPr>
            <p:spPr>
              <a:xfrm>
                <a:off x="1822680" y="556200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0" name=""/>
              <p:cNvSpPr/>
              <p:nvPr/>
            </p:nvSpPr>
            <p:spPr>
              <a:xfrm flipV="1">
                <a:off x="1912320" y="551628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1" name=""/>
              <p:cNvSpPr/>
              <p:nvPr/>
            </p:nvSpPr>
            <p:spPr>
              <a:xfrm>
                <a:off x="1912320" y="551664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2" name=""/>
              <p:cNvSpPr/>
              <p:nvPr/>
            </p:nvSpPr>
            <p:spPr>
              <a:xfrm flipV="1">
                <a:off x="1942200" y="54864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3" name=""/>
              <p:cNvSpPr/>
              <p:nvPr/>
            </p:nvSpPr>
            <p:spPr>
              <a:xfrm>
                <a:off x="1942200" y="548676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4" name=""/>
              <p:cNvSpPr/>
              <p:nvPr/>
            </p:nvSpPr>
            <p:spPr>
              <a:xfrm>
                <a:off x="1942200" y="5516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5" name=""/>
              <p:cNvSpPr/>
              <p:nvPr/>
            </p:nvSpPr>
            <p:spPr>
              <a:xfrm>
                <a:off x="1942200" y="554652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6" name=""/>
              <p:cNvSpPr/>
              <p:nvPr/>
            </p:nvSpPr>
            <p:spPr>
              <a:xfrm flipV="1">
                <a:off x="2031840" y="55162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7" name=""/>
              <p:cNvSpPr/>
              <p:nvPr/>
            </p:nvSpPr>
            <p:spPr>
              <a:xfrm>
                <a:off x="2031840" y="551664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8" name=""/>
              <p:cNvSpPr/>
              <p:nvPr/>
            </p:nvSpPr>
            <p:spPr>
              <a:xfrm>
                <a:off x="2031840" y="55465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9" name=""/>
              <p:cNvSpPr/>
              <p:nvPr/>
            </p:nvSpPr>
            <p:spPr>
              <a:xfrm>
                <a:off x="2031840" y="556200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0" name=""/>
              <p:cNvSpPr/>
              <p:nvPr/>
            </p:nvSpPr>
            <p:spPr>
              <a:xfrm>
                <a:off x="1912320" y="55620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1" name=""/>
              <p:cNvSpPr/>
              <p:nvPr/>
            </p:nvSpPr>
            <p:spPr>
              <a:xfrm>
                <a:off x="1912320" y="5606280"/>
                <a:ext cx="29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2" name=""/>
              <p:cNvSpPr/>
              <p:nvPr/>
            </p:nvSpPr>
            <p:spPr>
              <a:xfrm>
                <a:off x="1822680" y="563616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"/>
              <p:cNvSpPr/>
              <p:nvPr/>
            </p:nvSpPr>
            <p:spPr>
              <a:xfrm>
                <a:off x="1822680" y="571068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"/>
              <p:cNvSpPr/>
              <p:nvPr/>
            </p:nvSpPr>
            <p:spPr>
              <a:xfrm flipV="1">
                <a:off x="1927080" y="566568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5" name=""/>
              <p:cNvSpPr/>
              <p:nvPr/>
            </p:nvSpPr>
            <p:spPr>
              <a:xfrm>
                <a:off x="1927080" y="566604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6" name=""/>
              <p:cNvSpPr/>
              <p:nvPr/>
            </p:nvSpPr>
            <p:spPr>
              <a:xfrm flipV="1">
                <a:off x="2016720" y="56509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7" name=""/>
              <p:cNvSpPr/>
              <p:nvPr/>
            </p:nvSpPr>
            <p:spPr>
              <a:xfrm>
                <a:off x="2016720" y="565092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8" name=""/>
              <p:cNvSpPr/>
              <p:nvPr/>
            </p:nvSpPr>
            <p:spPr>
              <a:xfrm>
                <a:off x="2016720" y="56660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9" name=""/>
              <p:cNvSpPr/>
              <p:nvPr/>
            </p:nvSpPr>
            <p:spPr>
              <a:xfrm>
                <a:off x="2016720" y="56959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"/>
              <p:cNvSpPr/>
              <p:nvPr/>
            </p:nvSpPr>
            <p:spPr>
              <a:xfrm>
                <a:off x="1927080" y="571068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"/>
              <p:cNvSpPr/>
              <p:nvPr/>
            </p:nvSpPr>
            <p:spPr>
              <a:xfrm>
                <a:off x="1927080" y="575532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 flipV="1">
                <a:off x="2016720" y="57405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"/>
              <p:cNvSpPr/>
              <p:nvPr/>
            </p:nvSpPr>
            <p:spPr>
              <a:xfrm>
                <a:off x="2016720" y="574056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"/>
              <p:cNvSpPr/>
              <p:nvPr/>
            </p:nvSpPr>
            <p:spPr>
              <a:xfrm>
                <a:off x="2016720" y="57553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5" name=""/>
              <p:cNvSpPr/>
              <p:nvPr/>
            </p:nvSpPr>
            <p:spPr>
              <a:xfrm>
                <a:off x="2016720" y="577044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>
                <a:off x="1792800" y="572580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7" name=""/>
              <p:cNvSpPr/>
              <p:nvPr/>
            </p:nvSpPr>
            <p:spPr>
              <a:xfrm>
                <a:off x="1792800" y="584496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8" name=""/>
              <p:cNvSpPr/>
              <p:nvPr/>
            </p:nvSpPr>
            <p:spPr>
              <a:xfrm flipV="1">
                <a:off x="1942200" y="58147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9" name=""/>
              <p:cNvSpPr/>
              <p:nvPr/>
            </p:nvSpPr>
            <p:spPr>
              <a:xfrm>
                <a:off x="1942200" y="581508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0" name=""/>
              <p:cNvSpPr/>
              <p:nvPr/>
            </p:nvSpPr>
            <p:spPr>
              <a:xfrm>
                <a:off x="1942200" y="58449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1" name=""/>
              <p:cNvSpPr/>
              <p:nvPr/>
            </p:nvSpPr>
            <p:spPr>
              <a:xfrm>
                <a:off x="1942200" y="5860080"/>
                <a:ext cx="148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2" name=""/>
              <p:cNvSpPr/>
              <p:nvPr/>
            </p:nvSpPr>
            <p:spPr>
              <a:xfrm>
                <a:off x="1778040" y="5815080"/>
                <a:ext cx="0" cy="104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3" name=""/>
              <p:cNvSpPr/>
              <p:nvPr/>
            </p:nvSpPr>
            <p:spPr>
              <a:xfrm>
                <a:off x="1778040" y="5919840"/>
                <a:ext cx="23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4" name=""/>
              <p:cNvSpPr/>
              <p:nvPr/>
            </p:nvSpPr>
            <p:spPr>
              <a:xfrm flipV="1">
                <a:off x="2016720" y="59047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5" name=""/>
              <p:cNvSpPr/>
              <p:nvPr/>
            </p:nvSpPr>
            <p:spPr>
              <a:xfrm>
                <a:off x="2016720" y="590472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6" name=""/>
              <p:cNvSpPr/>
              <p:nvPr/>
            </p:nvSpPr>
            <p:spPr>
              <a:xfrm>
                <a:off x="2016720" y="591984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"/>
              <p:cNvSpPr/>
              <p:nvPr/>
            </p:nvSpPr>
            <p:spPr>
              <a:xfrm>
                <a:off x="2016720" y="5949360"/>
                <a:ext cx="35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"/>
              <p:cNvSpPr/>
              <p:nvPr/>
            </p:nvSpPr>
            <p:spPr>
              <a:xfrm>
                <a:off x="1584000" y="5949360"/>
                <a:ext cx="0" cy="149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"/>
              <p:cNvSpPr/>
              <p:nvPr/>
            </p:nvSpPr>
            <p:spPr>
              <a:xfrm>
                <a:off x="1584000" y="6098760"/>
                <a:ext cx="388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"/>
              <p:cNvSpPr/>
              <p:nvPr/>
            </p:nvSpPr>
            <p:spPr>
              <a:xfrm flipV="1">
                <a:off x="1972080" y="602424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"/>
              <p:cNvSpPr/>
              <p:nvPr/>
            </p:nvSpPr>
            <p:spPr>
              <a:xfrm>
                <a:off x="1972080" y="602424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"/>
              <p:cNvSpPr/>
              <p:nvPr/>
            </p:nvSpPr>
            <p:spPr>
              <a:xfrm flipV="1">
                <a:off x="2031840" y="597888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"/>
              <p:cNvSpPr/>
              <p:nvPr/>
            </p:nvSpPr>
            <p:spPr>
              <a:xfrm>
                <a:off x="2031840" y="5979240"/>
                <a:ext cx="4172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"/>
              <p:cNvSpPr/>
              <p:nvPr/>
            </p:nvSpPr>
            <p:spPr>
              <a:xfrm>
                <a:off x="2031840" y="60242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"/>
              <p:cNvSpPr/>
              <p:nvPr/>
            </p:nvSpPr>
            <p:spPr>
              <a:xfrm>
                <a:off x="2031840" y="6054120"/>
                <a:ext cx="32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"/>
              <p:cNvSpPr/>
              <p:nvPr/>
            </p:nvSpPr>
            <p:spPr>
              <a:xfrm flipV="1">
                <a:off x="2360160" y="60238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"/>
              <p:cNvSpPr/>
              <p:nvPr/>
            </p:nvSpPr>
            <p:spPr>
              <a:xfrm>
                <a:off x="2360160" y="6024240"/>
                <a:ext cx="118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"/>
              <p:cNvSpPr/>
              <p:nvPr/>
            </p:nvSpPr>
            <p:spPr>
              <a:xfrm>
                <a:off x="2360160" y="60541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"/>
              <p:cNvSpPr/>
              <p:nvPr/>
            </p:nvSpPr>
            <p:spPr>
              <a:xfrm>
                <a:off x="2360160" y="606888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"/>
              <p:cNvSpPr/>
              <p:nvPr/>
            </p:nvSpPr>
            <p:spPr>
              <a:xfrm>
                <a:off x="1972080" y="609876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"/>
              <p:cNvSpPr/>
              <p:nvPr/>
            </p:nvSpPr>
            <p:spPr>
              <a:xfrm>
                <a:off x="1972080" y="620316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"/>
              <p:cNvSpPr/>
              <p:nvPr/>
            </p:nvSpPr>
            <p:spPr>
              <a:xfrm flipV="1">
                <a:off x="2180880" y="61581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"/>
              <p:cNvSpPr/>
              <p:nvPr/>
            </p:nvSpPr>
            <p:spPr>
              <a:xfrm>
                <a:off x="2180880" y="615852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"/>
              <p:cNvSpPr/>
              <p:nvPr/>
            </p:nvSpPr>
            <p:spPr>
              <a:xfrm flipV="1">
                <a:off x="2315160" y="61282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"/>
              <p:cNvSpPr/>
              <p:nvPr/>
            </p:nvSpPr>
            <p:spPr>
              <a:xfrm>
                <a:off x="2315160" y="612864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"/>
              <p:cNvSpPr/>
              <p:nvPr/>
            </p:nvSpPr>
            <p:spPr>
              <a:xfrm flipV="1">
                <a:off x="2390040" y="61135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"/>
              <p:cNvSpPr/>
              <p:nvPr/>
            </p:nvSpPr>
            <p:spPr>
              <a:xfrm>
                <a:off x="2390040" y="6113520"/>
                <a:ext cx="26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"/>
              <p:cNvSpPr/>
              <p:nvPr/>
            </p:nvSpPr>
            <p:spPr>
              <a:xfrm>
                <a:off x="2390040" y="6128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>
                <a:off x="2390040" y="615852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"/>
              <p:cNvSpPr/>
              <p:nvPr/>
            </p:nvSpPr>
            <p:spPr>
              <a:xfrm>
                <a:off x="2315160" y="61585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"/>
              <p:cNvSpPr/>
              <p:nvPr/>
            </p:nvSpPr>
            <p:spPr>
              <a:xfrm>
                <a:off x="2315160" y="6188400"/>
                <a:ext cx="26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2" name=""/>
              <p:cNvSpPr/>
              <p:nvPr/>
            </p:nvSpPr>
            <p:spPr>
              <a:xfrm>
                <a:off x="2180880" y="62031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3" name=""/>
              <p:cNvSpPr/>
              <p:nvPr/>
            </p:nvSpPr>
            <p:spPr>
              <a:xfrm>
                <a:off x="2180880" y="6233040"/>
                <a:ext cx="4478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4" name=""/>
              <p:cNvSpPr/>
              <p:nvPr/>
            </p:nvSpPr>
            <p:spPr>
              <a:xfrm>
                <a:off x="1494360" y="6068880"/>
                <a:ext cx="0" cy="22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5" name=""/>
              <p:cNvSpPr/>
              <p:nvPr/>
            </p:nvSpPr>
            <p:spPr>
              <a:xfrm>
                <a:off x="1494360" y="6292800"/>
                <a:ext cx="1224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6" name=""/>
              <p:cNvSpPr/>
              <p:nvPr/>
            </p:nvSpPr>
            <p:spPr>
              <a:xfrm flipV="1">
                <a:off x="2718360" y="627804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7" name=""/>
              <p:cNvSpPr/>
              <p:nvPr/>
            </p:nvSpPr>
            <p:spPr>
              <a:xfrm>
                <a:off x="2718360" y="627804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8" name=""/>
              <p:cNvSpPr/>
              <p:nvPr/>
            </p:nvSpPr>
            <p:spPr>
              <a:xfrm>
                <a:off x="2718360" y="62928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9" name=""/>
              <p:cNvSpPr/>
              <p:nvPr/>
            </p:nvSpPr>
            <p:spPr>
              <a:xfrm>
                <a:off x="2718360" y="6322680"/>
                <a:ext cx="118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0" name=""/>
              <p:cNvSpPr/>
              <p:nvPr/>
            </p:nvSpPr>
            <p:spPr>
              <a:xfrm>
                <a:off x="1464480" y="6292800"/>
                <a:ext cx="0" cy="253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1" name=""/>
              <p:cNvSpPr/>
              <p:nvPr/>
            </p:nvSpPr>
            <p:spPr>
              <a:xfrm>
                <a:off x="1464480" y="654660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2" name=""/>
              <p:cNvSpPr/>
              <p:nvPr/>
            </p:nvSpPr>
            <p:spPr>
              <a:xfrm flipV="1">
                <a:off x="1628640" y="641232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3" name=""/>
              <p:cNvSpPr/>
              <p:nvPr/>
            </p:nvSpPr>
            <p:spPr>
              <a:xfrm>
                <a:off x="1628640" y="641232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4" name=""/>
              <p:cNvSpPr/>
              <p:nvPr/>
            </p:nvSpPr>
            <p:spPr>
              <a:xfrm flipV="1">
                <a:off x="1778040" y="636696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"/>
              <p:cNvSpPr/>
              <p:nvPr/>
            </p:nvSpPr>
            <p:spPr>
              <a:xfrm>
                <a:off x="1778040" y="636732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"/>
              <p:cNvSpPr/>
              <p:nvPr/>
            </p:nvSpPr>
            <p:spPr>
              <a:xfrm>
                <a:off x="1778040" y="64123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"/>
              <p:cNvSpPr/>
              <p:nvPr/>
            </p:nvSpPr>
            <p:spPr>
              <a:xfrm>
                <a:off x="1778040" y="644220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"/>
              <p:cNvSpPr/>
              <p:nvPr/>
            </p:nvSpPr>
            <p:spPr>
              <a:xfrm flipV="1">
                <a:off x="1867680" y="639684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"/>
              <p:cNvSpPr/>
              <p:nvPr/>
            </p:nvSpPr>
            <p:spPr>
              <a:xfrm>
                <a:off x="1867680" y="6397200"/>
                <a:ext cx="746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"/>
              <p:cNvSpPr/>
              <p:nvPr/>
            </p:nvSpPr>
            <p:spPr>
              <a:xfrm>
                <a:off x="1867680" y="644220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"/>
              <p:cNvSpPr/>
              <p:nvPr/>
            </p:nvSpPr>
            <p:spPr>
              <a:xfrm>
                <a:off x="1867680" y="6471720"/>
                <a:ext cx="46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"/>
              <p:cNvSpPr/>
              <p:nvPr/>
            </p:nvSpPr>
            <p:spPr>
              <a:xfrm flipV="1">
                <a:off x="2330280" y="644184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"/>
              <p:cNvSpPr/>
              <p:nvPr/>
            </p:nvSpPr>
            <p:spPr>
              <a:xfrm>
                <a:off x="2330280" y="644220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"/>
              <p:cNvSpPr/>
              <p:nvPr/>
            </p:nvSpPr>
            <p:spPr>
              <a:xfrm>
                <a:off x="2330280" y="64717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"/>
              <p:cNvSpPr/>
              <p:nvPr/>
            </p:nvSpPr>
            <p:spPr>
              <a:xfrm>
                <a:off x="2330280" y="648684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"/>
              <p:cNvSpPr/>
              <p:nvPr/>
            </p:nvSpPr>
            <p:spPr>
              <a:xfrm>
                <a:off x="1628640" y="654660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"/>
              <p:cNvSpPr/>
              <p:nvPr/>
            </p:nvSpPr>
            <p:spPr>
              <a:xfrm>
                <a:off x="1628640" y="668088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"/>
              <p:cNvSpPr/>
              <p:nvPr/>
            </p:nvSpPr>
            <p:spPr>
              <a:xfrm flipV="1">
                <a:off x="1703520" y="660636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>
                <a:off x="1703520" y="660636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"/>
              <p:cNvSpPr/>
              <p:nvPr/>
            </p:nvSpPr>
            <p:spPr>
              <a:xfrm flipV="1">
                <a:off x="1956960" y="656100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"/>
              <p:cNvSpPr/>
              <p:nvPr/>
            </p:nvSpPr>
            <p:spPr>
              <a:xfrm>
                <a:off x="1956960" y="656136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"/>
              <p:cNvSpPr/>
              <p:nvPr/>
            </p:nvSpPr>
            <p:spPr>
              <a:xfrm flipV="1">
                <a:off x="2031840" y="6531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"/>
              <p:cNvSpPr/>
              <p:nvPr/>
            </p:nvSpPr>
            <p:spPr>
              <a:xfrm>
                <a:off x="2031840" y="653148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"/>
              <p:cNvSpPr/>
              <p:nvPr/>
            </p:nvSpPr>
            <p:spPr>
              <a:xfrm>
                <a:off x="2031840" y="6561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"/>
              <p:cNvSpPr/>
              <p:nvPr/>
            </p:nvSpPr>
            <p:spPr>
              <a:xfrm>
                <a:off x="2031840" y="659124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"/>
              <p:cNvSpPr/>
              <p:nvPr/>
            </p:nvSpPr>
            <p:spPr>
              <a:xfrm flipV="1">
                <a:off x="2106360" y="657648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>
                <a:off x="2106360" y="6576480"/>
                <a:ext cx="313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"/>
              <p:cNvSpPr/>
              <p:nvPr/>
            </p:nvSpPr>
            <p:spPr>
              <a:xfrm>
                <a:off x="2106360" y="65912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"/>
              <p:cNvSpPr/>
              <p:nvPr/>
            </p:nvSpPr>
            <p:spPr>
              <a:xfrm>
                <a:off x="2106360" y="6621120"/>
                <a:ext cx="358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>
                <a:off x="1956960" y="66063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1" name=""/>
              <p:cNvSpPr/>
              <p:nvPr/>
            </p:nvSpPr>
            <p:spPr>
              <a:xfrm>
                <a:off x="1956960" y="6651000"/>
                <a:ext cx="179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2" name=""/>
              <p:cNvSpPr/>
              <p:nvPr/>
            </p:nvSpPr>
            <p:spPr>
              <a:xfrm>
                <a:off x="1703520" y="668088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3" name=""/>
              <p:cNvSpPr/>
              <p:nvPr/>
            </p:nvSpPr>
            <p:spPr>
              <a:xfrm>
                <a:off x="1703520" y="677052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4" name=""/>
              <p:cNvSpPr/>
              <p:nvPr/>
            </p:nvSpPr>
            <p:spPr>
              <a:xfrm flipV="1">
                <a:off x="1882440" y="672516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>
                <a:off x="1882440" y="6725520"/>
                <a:ext cx="477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6" name=""/>
              <p:cNvSpPr/>
              <p:nvPr/>
            </p:nvSpPr>
            <p:spPr>
              <a:xfrm flipV="1">
                <a:off x="2360160" y="66952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7" name=""/>
              <p:cNvSpPr/>
              <p:nvPr/>
            </p:nvSpPr>
            <p:spPr>
              <a:xfrm>
                <a:off x="2360160" y="669564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8" name=""/>
              <p:cNvSpPr/>
              <p:nvPr/>
            </p:nvSpPr>
            <p:spPr>
              <a:xfrm>
                <a:off x="2360160" y="67255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"/>
              <p:cNvSpPr/>
              <p:nvPr/>
            </p:nvSpPr>
            <p:spPr>
              <a:xfrm>
                <a:off x="2360160" y="6740640"/>
                <a:ext cx="8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>
                <a:off x="1882440" y="67705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"/>
              <p:cNvSpPr/>
              <p:nvPr/>
            </p:nvSpPr>
            <p:spPr>
              <a:xfrm>
                <a:off x="1882440" y="680040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"/>
              <p:cNvSpPr/>
              <p:nvPr/>
            </p:nvSpPr>
            <p:spPr>
              <a:xfrm flipV="1">
                <a:off x="2031840" y="678528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>
                <a:off x="2031840" y="6785280"/>
                <a:ext cx="626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"/>
              <p:cNvSpPr/>
              <p:nvPr/>
            </p:nvSpPr>
            <p:spPr>
              <a:xfrm>
                <a:off x="2031840" y="680040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5" name=""/>
            <p:cNvGrpSpPr/>
            <p:nvPr/>
          </p:nvGrpSpPr>
          <p:grpSpPr>
            <a:xfrm>
              <a:off x="1225800" y="5875200"/>
              <a:ext cx="4000320" cy="3164040"/>
              <a:chOff x="1225800" y="5875200"/>
              <a:chExt cx="4000320" cy="3164040"/>
            </a:xfrm>
          </p:grpSpPr>
          <p:sp>
            <p:nvSpPr>
              <p:cNvPr id="646" name=""/>
              <p:cNvSpPr/>
              <p:nvPr/>
            </p:nvSpPr>
            <p:spPr>
              <a:xfrm>
                <a:off x="2031840" y="6829920"/>
                <a:ext cx="656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7" name=""/>
              <p:cNvSpPr/>
              <p:nvPr/>
            </p:nvSpPr>
            <p:spPr>
              <a:xfrm>
                <a:off x="1434240" y="6636600"/>
                <a:ext cx="0" cy="358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1434240" y="6994800"/>
                <a:ext cx="104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9" name=""/>
              <p:cNvSpPr/>
              <p:nvPr/>
            </p:nvSpPr>
            <p:spPr>
              <a:xfrm flipV="1">
                <a:off x="1539360" y="690480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0" name=""/>
              <p:cNvSpPr/>
              <p:nvPr/>
            </p:nvSpPr>
            <p:spPr>
              <a:xfrm>
                <a:off x="1539360" y="6905160"/>
                <a:ext cx="29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1" name=""/>
              <p:cNvSpPr/>
              <p:nvPr/>
            </p:nvSpPr>
            <p:spPr>
              <a:xfrm flipV="1">
                <a:off x="1568520" y="685980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2" name=""/>
              <p:cNvSpPr/>
              <p:nvPr/>
            </p:nvSpPr>
            <p:spPr>
              <a:xfrm>
                <a:off x="1568520" y="6860160"/>
                <a:ext cx="5522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>
                <a:off x="1568520" y="69051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4" name=""/>
              <p:cNvSpPr/>
              <p:nvPr/>
            </p:nvSpPr>
            <p:spPr>
              <a:xfrm>
                <a:off x="1568520" y="693504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 flipV="1">
                <a:off x="1688400" y="69048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1688400" y="6905160"/>
                <a:ext cx="761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1688400" y="69350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1688400" y="6964920"/>
                <a:ext cx="477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 flipV="1">
                <a:off x="2166120" y="694980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2166120" y="694980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2166120" y="69649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2166120" y="699480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1539360" y="699480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1539360" y="7113960"/>
                <a:ext cx="5223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 flipV="1">
                <a:off x="2061720" y="70689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2061720" y="7069320"/>
                <a:ext cx="8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 flipV="1">
                <a:off x="2151000" y="70390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2151000" y="703944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2151000" y="70693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0" name=""/>
              <p:cNvSpPr/>
              <p:nvPr/>
            </p:nvSpPr>
            <p:spPr>
              <a:xfrm>
                <a:off x="2151000" y="7099200"/>
                <a:ext cx="313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1" name=""/>
              <p:cNvSpPr/>
              <p:nvPr/>
            </p:nvSpPr>
            <p:spPr>
              <a:xfrm flipV="1">
                <a:off x="2464560" y="70689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2" name=""/>
              <p:cNvSpPr/>
              <p:nvPr/>
            </p:nvSpPr>
            <p:spPr>
              <a:xfrm>
                <a:off x="2464560" y="706932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3" name=""/>
              <p:cNvSpPr/>
              <p:nvPr/>
            </p:nvSpPr>
            <p:spPr>
              <a:xfrm>
                <a:off x="2464560" y="70992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>
                <a:off x="2464560" y="711396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5" name=""/>
              <p:cNvSpPr/>
              <p:nvPr/>
            </p:nvSpPr>
            <p:spPr>
              <a:xfrm>
                <a:off x="2061720" y="711396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6" name=""/>
              <p:cNvSpPr/>
              <p:nvPr/>
            </p:nvSpPr>
            <p:spPr>
              <a:xfrm>
                <a:off x="2061720" y="717372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7" name=""/>
              <p:cNvSpPr/>
              <p:nvPr/>
            </p:nvSpPr>
            <p:spPr>
              <a:xfrm flipV="1">
                <a:off x="2270520" y="71589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8" name=""/>
              <p:cNvSpPr/>
              <p:nvPr/>
            </p:nvSpPr>
            <p:spPr>
              <a:xfrm>
                <a:off x="2270520" y="715896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9" name=""/>
              <p:cNvSpPr/>
              <p:nvPr/>
            </p:nvSpPr>
            <p:spPr>
              <a:xfrm>
                <a:off x="2270520" y="71737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>
                <a:off x="2270520" y="7203600"/>
                <a:ext cx="477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1" name=""/>
              <p:cNvSpPr/>
              <p:nvPr/>
            </p:nvSpPr>
            <p:spPr>
              <a:xfrm>
                <a:off x="1225800" y="5875200"/>
                <a:ext cx="0" cy="28508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>
                <a:off x="1225800" y="8726040"/>
                <a:ext cx="283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 flipV="1">
                <a:off x="1509480" y="8427600"/>
                <a:ext cx="0" cy="298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1509480" y="8427600"/>
                <a:ext cx="13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 flipV="1">
                <a:off x="1643760" y="8158320"/>
                <a:ext cx="0" cy="268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1643760" y="815868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 flipV="1">
                <a:off x="1703520" y="7755840"/>
                <a:ext cx="0" cy="4024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1703520" y="775584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 flipV="1">
                <a:off x="1778040" y="7367760"/>
                <a:ext cx="0" cy="388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1778040" y="7367760"/>
                <a:ext cx="26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 flipV="1">
                <a:off x="2046600" y="73227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2046600" y="73231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 flipV="1">
                <a:off x="2076480" y="72928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2076480" y="729324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 flipV="1">
                <a:off x="2285280" y="72630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2285280" y="7263360"/>
                <a:ext cx="26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 flipV="1">
                <a:off x="2554200" y="724824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2554200" y="7248240"/>
                <a:ext cx="22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2554200" y="72633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2554200" y="7278120"/>
                <a:ext cx="4924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2285280" y="72932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2285280" y="7323120"/>
                <a:ext cx="298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2076480" y="732312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2076480" y="7367760"/>
                <a:ext cx="596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2046600" y="736776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2046600" y="7412400"/>
                <a:ext cx="612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1778040" y="7755840"/>
                <a:ext cx="0" cy="3427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1778040" y="8098920"/>
                <a:ext cx="13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 flipV="1">
                <a:off x="1912320" y="802440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1912320" y="802440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 flipV="1">
                <a:off x="2031840" y="791964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2031840" y="792000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 flipV="1">
                <a:off x="2061720" y="7740720"/>
                <a:ext cx="0" cy="179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>
                <a:off x="2061720" y="7740720"/>
                <a:ext cx="29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 flipV="1">
                <a:off x="2360160" y="766620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2360160" y="7666200"/>
                <a:ext cx="5223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 flipV="1">
                <a:off x="2882880" y="759168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>
                <a:off x="2882880" y="7591680"/>
                <a:ext cx="23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 flipV="1">
                <a:off x="3121200" y="750168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3121200" y="7502040"/>
                <a:ext cx="26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 flipV="1">
                <a:off x="3390120" y="74570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3390120" y="7457400"/>
                <a:ext cx="403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3390120" y="75020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3390120" y="7546680"/>
                <a:ext cx="45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 flipV="1">
                <a:off x="3435120" y="7487280"/>
                <a:ext cx="0" cy="59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3435120" y="7487280"/>
                <a:ext cx="477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3435120" y="754668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3435120" y="7591680"/>
                <a:ext cx="506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 flipV="1">
                <a:off x="3942360" y="7561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3942360" y="756180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 flipV="1">
                <a:off x="4061880" y="75315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4061880" y="75319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4061880" y="75618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4061880" y="757656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3942360" y="75916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3942360" y="7621560"/>
                <a:ext cx="46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3121200" y="759168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>
                <a:off x="3121200" y="7681320"/>
                <a:ext cx="388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 flipV="1">
                <a:off x="3509640" y="766620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>
                <a:off x="3509640" y="7666200"/>
                <a:ext cx="5374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3509640" y="76813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>
                <a:off x="3509640" y="7711200"/>
                <a:ext cx="343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2882880" y="766620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>
                <a:off x="2882880" y="7770600"/>
                <a:ext cx="1149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 flipV="1">
                <a:off x="4032000" y="7740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4032000" y="7740720"/>
                <a:ext cx="417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4032000" y="777060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>
                <a:off x="4032000" y="778572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2360160" y="7740720"/>
                <a:ext cx="0" cy="896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2840" bIns="42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2360160" y="7830360"/>
                <a:ext cx="746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2061720" y="7920000"/>
                <a:ext cx="0" cy="149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2061720" y="8069400"/>
                <a:ext cx="29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 flipV="1">
                <a:off x="2091240" y="802404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2091240" y="8024400"/>
                <a:ext cx="74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 flipV="1">
                <a:off x="2166120" y="79941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2166120" y="79945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 flipV="1">
                <a:off x="2196000" y="794952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2196000" y="794988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 flipV="1">
                <a:off x="2300400" y="7919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2300400" y="792000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 flipV="1">
                <a:off x="2509200" y="78897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2509200" y="789012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 flipV="1">
                <a:off x="2568960" y="78753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2568960" y="78753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>
                <a:off x="2568960" y="78901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2568960" y="7920000"/>
                <a:ext cx="1388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>
                <a:off x="2509200" y="79200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>
                <a:off x="2509200" y="79498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>
                <a:off x="2300400" y="794988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>
                <a:off x="2300400" y="7994520"/>
                <a:ext cx="925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>
                <a:off x="2196000" y="799452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>
                <a:off x="2196000" y="8039520"/>
                <a:ext cx="388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>
                <a:off x="2166120" y="802440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>
                <a:off x="2166120" y="8084160"/>
                <a:ext cx="567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>
                <a:off x="2091240" y="8069400"/>
                <a:ext cx="0" cy="59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>
                <a:off x="2091240" y="8128800"/>
                <a:ext cx="641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>
                <a:off x="2031840" y="802440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"/>
              <p:cNvSpPr/>
              <p:nvPr/>
            </p:nvSpPr>
            <p:spPr>
              <a:xfrm>
                <a:off x="2031840" y="8158680"/>
                <a:ext cx="775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>
                <a:off x="1912320" y="8098920"/>
                <a:ext cx="0" cy="104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>
                <a:off x="1912320" y="8203680"/>
                <a:ext cx="686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"/>
              <p:cNvSpPr/>
              <p:nvPr/>
            </p:nvSpPr>
            <p:spPr>
              <a:xfrm>
                <a:off x="1703520" y="8158680"/>
                <a:ext cx="0" cy="4032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"/>
              <p:cNvSpPr/>
              <p:nvPr/>
            </p:nvSpPr>
            <p:spPr>
              <a:xfrm>
                <a:off x="1703520" y="8561880"/>
                <a:ext cx="7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"/>
              <p:cNvSpPr/>
              <p:nvPr/>
            </p:nvSpPr>
            <p:spPr>
              <a:xfrm flipV="1">
                <a:off x="1778040" y="8442360"/>
                <a:ext cx="0" cy="1195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"/>
              <p:cNvSpPr/>
              <p:nvPr/>
            </p:nvSpPr>
            <p:spPr>
              <a:xfrm>
                <a:off x="1778040" y="844236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"/>
              <p:cNvSpPr/>
              <p:nvPr/>
            </p:nvSpPr>
            <p:spPr>
              <a:xfrm flipV="1">
                <a:off x="1972080" y="8337600"/>
                <a:ext cx="0" cy="104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"/>
              <p:cNvSpPr/>
              <p:nvPr/>
            </p:nvSpPr>
            <p:spPr>
              <a:xfrm>
                <a:off x="1972080" y="8337960"/>
                <a:ext cx="1402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"/>
              <p:cNvSpPr/>
              <p:nvPr/>
            </p:nvSpPr>
            <p:spPr>
              <a:xfrm flipV="1">
                <a:off x="3375360" y="827820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"/>
              <p:cNvSpPr/>
              <p:nvPr/>
            </p:nvSpPr>
            <p:spPr>
              <a:xfrm>
                <a:off x="3375360" y="827820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"/>
              <p:cNvSpPr/>
              <p:nvPr/>
            </p:nvSpPr>
            <p:spPr>
              <a:xfrm flipV="1">
                <a:off x="3539520" y="82479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"/>
              <p:cNvSpPr/>
              <p:nvPr/>
            </p:nvSpPr>
            <p:spPr>
              <a:xfrm>
                <a:off x="3539520" y="8248320"/>
                <a:ext cx="1149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"/>
              <p:cNvSpPr/>
              <p:nvPr/>
            </p:nvSpPr>
            <p:spPr>
              <a:xfrm>
                <a:off x="3539520" y="827820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"/>
              <p:cNvSpPr/>
              <p:nvPr/>
            </p:nvSpPr>
            <p:spPr>
              <a:xfrm>
                <a:off x="3539520" y="8292960"/>
                <a:ext cx="820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>
                <a:off x="3375360" y="8337960"/>
                <a:ext cx="0" cy="74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360" bIns="27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>
                <a:off x="3375360" y="8412480"/>
                <a:ext cx="32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 flipV="1">
                <a:off x="3703680" y="83822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>
                <a:off x="3703680" y="8382600"/>
                <a:ext cx="20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 flipV="1">
                <a:off x="3912480" y="8352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>
                <a:off x="3912480" y="8352720"/>
                <a:ext cx="268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 flipV="1">
                <a:off x="4181400" y="83379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"/>
              <p:cNvSpPr/>
              <p:nvPr/>
            </p:nvSpPr>
            <p:spPr>
              <a:xfrm>
                <a:off x="4181400" y="833796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"/>
              <p:cNvSpPr/>
              <p:nvPr/>
            </p:nvSpPr>
            <p:spPr>
              <a:xfrm>
                <a:off x="4181400" y="83527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"/>
              <p:cNvSpPr/>
              <p:nvPr/>
            </p:nvSpPr>
            <p:spPr>
              <a:xfrm>
                <a:off x="4181400" y="8367840"/>
                <a:ext cx="1044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"/>
              <p:cNvSpPr/>
              <p:nvPr/>
            </p:nvSpPr>
            <p:spPr>
              <a:xfrm>
                <a:off x="3912480" y="83826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"/>
              <p:cNvSpPr/>
              <p:nvPr/>
            </p:nvSpPr>
            <p:spPr>
              <a:xfrm>
                <a:off x="3912480" y="8412480"/>
                <a:ext cx="1029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"/>
              <p:cNvSpPr/>
              <p:nvPr/>
            </p:nvSpPr>
            <p:spPr>
              <a:xfrm>
                <a:off x="3703680" y="841248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"/>
              <p:cNvSpPr/>
              <p:nvPr/>
            </p:nvSpPr>
            <p:spPr>
              <a:xfrm>
                <a:off x="3703680" y="8457120"/>
                <a:ext cx="865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"/>
              <p:cNvSpPr/>
              <p:nvPr/>
            </p:nvSpPr>
            <p:spPr>
              <a:xfrm>
                <a:off x="1972080" y="844236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>
                <a:off x="1972080" y="8502120"/>
                <a:ext cx="506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"/>
              <p:cNvSpPr/>
              <p:nvPr/>
            </p:nvSpPr>
            <p:spPr>
              <a:xfrm>
                <a:off x="1778040" y="8561880"/>
                <a:ext cx="0" cy="1188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"/>
              <p:cNvSpPr/>
              <p:nvPr/>
            </p:nvSpPr>
            <p:spPr>
              <a:xfrm>
                <a:off x="1778040" y="8681040"/>
                <a:ext cx="29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"/>
              <p:cNvSpPr/>
              <p:nvPr/>
            </p:nvSpPr>
            <p:spPr>
              <a:xfrm flipV="1">
                <a:off x="2076480" y="86360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>
                <a:off x="2076480" y="8636400"/>
                <a:ext cx="149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"/>
              <p:cNvSpPr/>
              <p:nvPr/>
            </p:nvSpPr>
            <p:spPr>
              <a:xfrm flipV="1">
                <a:off x="2225880" y="857664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"/>
              <p:cNvSpPr/>
              <p:nvPr/>
            </p:nvSpPr>
            <p:spPr>
              <a:xfrm>
                <a:off x="2225880" y="857664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"/>
              <p:cNvSpPr/>
              <p:nvPr/>
            </p:nvSpPr>
            <p:spPr>
              <a:xfrm flipV="1">
                <a:off x="2419920" y="85464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>
                <a:off x="2419920" y="8546760"/>
                <a:ext cx="671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"/>
              <p:cNvSpPr/>
              <p:nvPr/>
            </p:nvSpPr>
            <p:spPr>
              <a:xfrm>
                <a:off x="2419920" y="85766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"/>
              <p:cNvSpPr/>
              <p:nvPr/>
            </p:nvSpPr>
            <p:spPr>
              <a:xfrm>
                <a:off x="2419920" y="8606520"/>
                <a:ext cx="4172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"/>
              <p:cNvSpPr/>
              <p:nvPr/>
            </p:nvSpPr>
            <p:spPr>
              <a:xfrm flipV="1">
                <a:off x="2837520" y="85917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>
                <a:off x="2837520" y="8591760"/>
                <a:ext cx="597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"/>
              <p:cNvSpPr/>
              <p:nvPr/>
            </p:nvSpPr>
            <p:spPr>
              <a:xfrm>
                <a:off x="2837520" y="86065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"/>
              <p:cNvSpPr/>
              <p:nvPr/>
            </p:nvSpPr>
            <p:spPr>
              <a:xfrm>
                <a:off x="2837520" y="8621280"/>
                <a:ext cx="761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>
                <a:off x="2225880" y="863640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"/>
              <p:cNvSpPr/>
              <p:nvPr/>
            </p:nvSpPr>
            <p:spPr>
              <a:xfrm>
                <a:off x="2225880" y="8696160"/>
                <a:ext cx="118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"/>
              <p:cNvSpPr/>
              <p:nvPr/>
            </p:nvSpPr>
            <p:spPr>
              <a:xfrm flipV="1">
                <a:off x="2345040" y="86659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"/>
              <p:cNvSpPr/>
              <p:nvPr/>
            </p:nvSpPr>
            <p:spPr>
              <a:xfrm>
                <a:off x="2345040" y="8666280"/>
                <a:ext cx="940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"/>
              <p:cNvSpPr/>
              <p:nvPr/>
            </p:nvSpPr>
            <p:spPr>
              <a:xfrm>
                <a:off x="2345040" y="86961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>
                <a:off x="2345040" y="8710920"/>
                <a:ext cx="612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"/>
              <p:cNvSpPr/>
              <p:nvPr/>
            </p:nvSpPr>
            <p:spPr>
              <a:xfrm>
                <a:off x="2076480" y="868104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"/>
              <p:cNvSpPr/>
              <p:nvPr/>
            </p:nvSpPr>
            <p:spPr>
              <a:xfrm>
                <a:off x="2076480" y="875592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"/>
              <p:cNvSpPr/>
              <p:nvPr/>
            </p:nvSpPr>
            <p:spPr>
              <a:xfrm>
                <a:off x="1643760" y="8427600"/>
                <a:ext cx="0" cy="3873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"/>
              <p:cNvSpPr/>
              <p:nvPr/>
            </p:nvSpPr>
            <p:spPr>
              <a:xfrm>
                <a:off x="1643760" y="8815320"/>
                <a:ext cx="582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 flipV="1">
                <a:off x="2225880" y="880056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"/>
              <p:cNvSpPr/>
              <p:nvPr/>
            </p:nvSpPr>
            <p:spPr>
              <a:xfrm>
                <a:off x="2225880" y="8800560"/>
                <a:ext cx="37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"/>
              <p:cNvSpPr/>
              <p:nvPr/>
            </p:nvSpPr>
            <p:spPr>
              <a:xfrm>
                <a:off x="2225880" y="88153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"/>
              <p:cNvSpPr/>
              <p:nvPr/>
            </p:nvSpPr>
            <p:spPr>
              <a:xfrm>
                <a:off x="2225880" y="8830440"/>
                <a:ext cx="29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>
                <a:off x="1509480" y="8726040"/>
                <a:ext cx="0" cy="3128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"/>
              <p:cNvSpPr/>
              <p:nvPr/>
            </p:nvSpPr>
            <p:spPr>
              <a:xfrm>
                <a:off x="1509480" y="9039240"/>
                <a:ext cx="19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"/>
              <p:cNvSpPr/>
              <p:nvPr/>
            </p:nvSpPr>
            <p:spPr>
              <a:xfrm flipV="1">
                <a:off x="1703520" y="89942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"/>
              <p:cNvSpPr/>
              <p:nvPr/>
            </p:nvSpPr>
            <p:spPr>
              <a:xfrm>
                <a:off x="1703520" y="8994600"/>
                <a:ext cx="1641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 flipV="1">
                <a:off x="1867680" y="893484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"/>
              <p:cNvSpPr/>
              <p:nvPr/>
            </p:nvSpPr>
            <p:spPr>
              <a:xfrm>
                <a:off x="1867680" y="8934840"/>
                <a:ext cx="1253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"/>
              <p:cNvSpPr/>
              <p:nvPr/>
            </p:nvSpPr>
            <p:spPr>
              <a:xfrm flipV="1">
                <a:off x="3121200" y="89046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"/>
              <p:cNvSpPr/>
              <p:nvPr/>
            </p:nvSpPr>
            <p:spPr>
              <a:xfrm>
                <a:off x="3121200" y="890496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 flipV="1">
                <a:off x="3241080" y="887472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46" name=""/>
            <p:cNvGrpSpPr/>
            <p:nvPr/>
          </p:nvGrpSpPr>
          <p:grpSpPr>
            <a:xfrm>
              <a:off x="1195920" y="561240"/>
              <a:ext cx="3328920" cy="9030240"/>
              <a:chOff x="1195920" y="561240"/>
              <a:chExt cx="3328920" cy="9030240"/>
            </a:xfrm>
          </p:grpSpPr>
          <p:sp>
            <p:nvSpPr>
              <p:cNvPr id="847" name=""/>
              <p:cNvSpPr/>
              <p:nvPr/>
            </p:nvSpPr>
            <p:spPr>
              <a:xfrm>
                <a:off x="3241080" y="8875080"/>
                <a:ext cx="298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>
                <a:off x="3241080" y="890496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>
                <a:off x="3241080" y="892008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>
                <a:off x="3121200" y="893484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>
                <a:off x="3121200" y="8979480"/>
                <a:ext cx="44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 flipV="1">
                <a:off x="3165840" y="89647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>
                <a:off x="3165840" y="8964720"/>
                <a:ext cx="151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>
                <a:off x="3165840" y="89794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>
                <a:off x="3165840" y="9009360"/>
                <a:ext cx="686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>
                <a:off x="1867680" y="8994600"/>
                <a:ext cx="0" cy="442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>
                <a:off x="1867680" y="9039240"/>
                <a:ext cx="9252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>
                <a:off x="1703520" y="903924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>
                <a:off x="1703520" y="9114120"/>
                <a:ext cx="745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 flipV="1">
                <a:off x="2449440" y="90838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>
                <a:off x="2449440" y="9084240"/>
                <a:ext cx="298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>
                <a:off x="2449440" y="91141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>
                <a:off x="2449440" y="9128880"/>
                <a:ext cx="283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>
                <a:off x="1195920" y="7218000"/>
                <a:ext cx="0" cy="21790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5" name=""/>
              <p:cNvSpPr/>
              <p:nvPr/>
            </p:nvSpPr>
            <p:spPr>
              <a:xfrm>
                <a:off x="1195920" y="9397440"/>
                <a:ext cx="4924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6" name=""/>
              <p:cNvSpPr/>
              <p:nvPr/>
            </p:nvSpPr>
            <p:spPr>
              <a:xfrm flipV="1">
                <a:off x="1688400" y="9263160"/>
                <a:ext cx="0" cy="133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7" name=""/>
              <p:cNvSpPr/>
              <p:nvPr/>
            </p:nvSpPr>
            <p:spPr>
              <a:xfrm>
                <a:off x="1688400" y="9263160"/>
                <a:ext cx="701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8" name=""/>
              <p:cNvSpPr/>
              <p:nvPr/>
            </p:nvSpPr>
            <p:spPr>
              <a:xfrm flipV="1">
                <a:off x="2390040" y="920340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9" name=""/>
              <p:cNvSpPr/>
              <p:nvPr/>
            </p:nvSpPr>
            <p:spPr>
              <a:xfrm>
                <a:off x="2390040" y="9203400"/>
                <a:ext cx="104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0" name=""/>
              <p:cNvSpPr/>
              <p:nvPr/>
            </p:nvSpPr>
            <p:spPr>
              <a:xfrm flipV="1">
                <a:off x="2494440" y="91731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1" name=""/>
              <p:cNvSpPr/>
              <p:nvPr/>
            </p:nvSpPr>
            <p:spPr>
              <a:xfrm>
                <a:off x="2494440" y="917352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2" name=""/>
              <p:cNvSpPr/>
              <p:nvPr/>
            </p:nvSpPr>
            <p:spPr>
              <a:xfrm>
                <a:off x="2494440" y="92034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3" name=""/>
              <p:cNvSpPr/>
              <p:nvPr/>
            </p:nvSpPr>
            <p:spPr>
              <a:xfrm>
                <a:off x="2494440" y="923328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4" name=""/>
              <p:cNvSpPr/>
              <p:nvPr/>
            </p:nvSpPr>
            <p:spPr>
              <a:xfrm flipV="1">
                <a:off x="2613960" y="92185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5" name=""/>
              <p:cNvSpPr/>
              <p:nvPr/>
            </p:nvSpPr>
            <p:spPr>
              <a:xfrm>
                <a:off x="2613960" y="9218520"/>
                <a:ext cx="5814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6" name=""/>
              <p:cNvSpPr/>
              <p:nvPr/>
            </p:nvSpPr>
            <p:spPr>
              <a:xfrm>
                <a:off x="2613960" y="923328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7" name=""/>
              <p:cNvSpPr/>
              <p:nvPr/>
            </p:nvSpPr>
            <p:spPr>
              <a:xfrm>
                <a:off x="2613960" y="9248400"/>
                <a:ext cx="8506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8" name=""/>
              <p:cNvSpPr/>
              <p:nvPr/>
            </p:nvSpPr>
            <p:spPr>
              <a:xfrm>
                <a:off x="2390040" y="9263160"/>
                <a:ext cx="0" cy="59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960" bIns="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9" name=""/>
              <p:cNvSpPr/>
              <p:nvPr/>
            </p:nvSpPr>
            <p:spPr>
              <a:xfrm>
                <a:off x="2390040" y="9322920"/>
                <a:ext cx="2530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0" name=""/>
              <p:cNvSpPr/>
              <p:nvPr/>
            </p:nvSpPr>
            <p:spPr>
              <a:xfrm flipV="1">
                <a:off x="2643480" y="92926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1" name=""/>
              <p:cNvSpPr/>
              <p:nvPr/>
            </p:nvSpPr>
            <p:spPr>
              <a:xfrm>
                <a:off x="2643480" y="9293040"/>
                <a:ext cx="373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2" name=""/>
              <p:cNvSpPr/>
              <p:nvPr/>
            </p:nvSpPr>
            <p:spPr>
              <a:xfrm>
                <a:off x="2643480" y="932292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3" name=""/>
              <p:cNvSpPr/>
              <p:nvPr/>
            </p:nvSpPr>
            <p:spPr>
              <a:xfrm>
                <a:off x="2643480" y="9337680"/>
                <a:ext cx="3434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4" name=""/>
              <p:cNvSpPr/>
              <p:nvPr/>
            </p:nvSpPr>
            <p:spPr>
              <a:xfrm>
                <a:off x="1688400" y="9397440"/>
                <a:ext cx="0" cy="1047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5" name=""/>
              <p:cNvSpPr/>
              <p:nvPr/>
            </p:nvSpPr>
            <p:spPr>
              <a:xfrm>
                <a:off x="1688400" y="9502200"/>
                <a:ext cx="1195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6" name=""/>
              <p:cNvSpPr/>
              <p:nvPr/>
            </p:nvSpPr>
            <p:spPr>
              <a:xfrm flipV="1">
                <a:off x="1807920" y="9427320"/>
                <a:ext cx="0" cy="74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7" name=""/>
              <p:cNvSpPr/>
              <p:nvPr/>
            </p:nvSpPr>
            <p:spPr>
              <a:xfrm>
                <a:off x="1807920" y="9427320"/>
                <a:ext cx="1785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8" name=""/>
              <p:cNvSpPr/>
              <p:nvPr/>
            </p:nvSpPr>
            <p:spPr>
              <a:xfrm flipV="1">
                <a:off x="1986840" y="939708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9" name=""/>
              <p:cNvSpPr/>
              <p:nvPr/>
            </p:nvSpPr>
            <p:spPr>
              <a:xfrm>
                <a:off x="1986840" y="939744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 flipV="1">
                <a:off x="2076480" y="9382680"/>
                <a:ext cx="0" cy="14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400" bIns="-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1" name=""/>
              <p:cNvSpPr/>
              <p:nvPr/>
            </p:nvSpPr>
            <p:spPr>
              <a:xfrm>
                <a:off x="2076480" y="938268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2" name=""/>
              <p:cNvSpPr/>
              <p:nvPr/>
            </p:nvSpPr>
            <p:spPr>
              <a:xfrm>
                <a:off x="2076480" y="939744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3" name=""/>
              <p:cNvSpPr/>
              <p:nvPr/>
            </p:nvSpPr>
            <p:spPr>
              <a:xfrm>
                <a:off x="2076480" y="9427320"/>
                <a:ext cx="298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>
                <a:off x="1986840" y="9427320"/>
                <a:ext cx="0" cy="450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5" name=""/>
              <p:cNvSpPr/>
              <p:nvPr/>
            </p:nvSpPr>
            <p:spPr>
              <a:xfrm>
                <a:off x="1986840" y="9472320"/>
                <a:ext cx="4478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6" name=""/>
              <p:cNvSpPr/>
              <p:nvPr/>
            </p:nvSpPr>
            <p:spPr>
              <a:xfrm>
                <a:off x="1807920" y="9502200"/>
                <a:ext cx="0" cy="5904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2240" bIns="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7" name=""/>
              <p:cNvSpPr/>
              <p:nvPr/>
            </p:nvSpPr>
            <p:spPr>
              <a:xfrm>
                <a:off x="1807920" y="9561600"/>
                <a:ext cx="896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8" name=""/>
              <p:cNvSpPr/>
              <p:nvPr/>
            </p:nvSpPr>
            <p:spPr>
              <a:xfrm flipV="1">
                <a:off x="1897560" y="953136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>
                <a:off x="1897560" y="9531720"/>
                <a:ext cx="5904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0" name=""/>
              <p:cNvSpPr/>
              <p:nvPr/>
            </p:nvSpPr>
            <p:spPr>
              <a:xfrm flipV="1">
                <a:off x="1956960" y="9501840"/>
                <a:ext cx="0" cy="2916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1" name=""/>
              <p:cNvSpPr/>
              <p:nvPr/>
            </p:nvSpPr>
            <p:spPr>
              <a:xfrm>
                <a:off x="1956960" y="9502200"/>
                <a:ext cx="2538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2" name=""/>
              <p:cNvSpPr/>
              <p:nvPr/>
            </p:nvSpPr>
            <p:spPr>
              <a:xfrm>
                <a:off x="1956960" y="9531720"/>
                <a:ext cx="0" cy="151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1680" bIns="-31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3" name=""/>
              <p:cNvSpPr/>
              <p:nvPr/>
            </p:nvSpPr>
            <p:spPr>
              <a:xfrm>
                <a:off x="1956960" y="9546840"/>
                <a:ext cx="133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1897560" y="9561600"/>
                <a:ext cx="0" cy="298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920" bIns="-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5" name=""/>
              <p:cNvSpPr/>
              <p:nvPr/>
            </p:nvSpPr>
            <p:spPr>
              <a:xfrm>
                <a:off x="1897560" y="9591480"/>
                <a:ext cx="3283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6" name=""/>
              <p:cNvSpPr/>
              <p:nvPr/>
            </p:nvSpPr>
            <p:spPr>
              <a:xfrm>
                <a:off x="2750040" y="5612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316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7" name=""/>
              <p:cNvSpPr/>
              <p:nvPr/>
            </p:nvSpPr>
            <p:spPr>
              <a:xfrm>
                <a:off x="3033360" y="5911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316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>
                <a:off x="2869200" y="6354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8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9" name=""/>
              <p:cNvSpPr/>
              <p:nvPr/>
            </p:nvSpPr>
            <p:spPr>
              <a:xfrm>
                <a:off x="2391840" y="6807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486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0" name=""/>
              <p:cNvSpPr/>
              <p:nvPr/>
            </p:nvSpPr>
            <p:spPr>
              <a:xfrm>
                <a:off x="3033360" y="7254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65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1" name=""/>
              <p:cNvSpPr/>
              <p:nvPr/>
            </p:nvSpPr>
            <p:spPr>
              <a:xfrm>
                <a:off x="2824560" y="7696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66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2" name=""/>
              <p:cNvSpPr/>
              <p:nvPr/>
            </p:nvSpPr>
            <p:spPr>
              <a:xfrm>
                <a:off x="2824560" y="7995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9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>
                <a:off x="2391840" y="8449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653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4" name=""/>
              <p:cNvSpPr/>
              <p:nvPr/>
            </p:nvSpPr>
            <p:spPr>
              <a:xfrm>
                <a:off x="2496240" y="8895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653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5" name=""/>
              <p:cNvSpPr/>
              <p:nvPr/>
            </p:nvSpPr>
            <p:spPr>
              <a:xfrm>
                <a:off x="2974320" y="9338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287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6" name=""/>
              <p:cNvSpPr/>
              <p:nvPr/>
            </p:nvSpPr>
            <p:spPr>
              <a:xfrm>
                <a:off x="2106720" y="9792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058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>
                <a:off x="2405520" y="10090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66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8" name=""/>
              <p:cNvSpPr/>
              <p:nvPr/>
            </p:nvSpPr>
            <p:spPr>
              <a:xfrm>
                <a:off x="2365920" y="10537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184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9" name=""/>
              <p:cNvSpPr/>
              <p:nvPr/>
            </p:nvSpPr>
            <p:spPr>
              <a:xfrm>
                <a:off x="2082240" y="10980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184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0" name=""/>
              <p:cNvSpPr/>
              <p:nvPr/>
            </p:nvSpPr>
            <p:spPr>
              <a:xfrm>
                <a:off x="2873520" y="114336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376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1" name=""/>
              <p:cNvSpPr/>
              <p:nvPr/>
            </p:nvSpPr>
            <p:spPr>
              <a:xfrm>
                <a:off x="2291400" y="11880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386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>
                <a:off x="3395880" y="12178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4g248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3" name=""/>
              <p:cNvSpPr/>
              <p:nvPr/>
            </p:nvSpPr>
            <p:spPr>
              <a:xfrm>
                <a:off x="3366000" y="12628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4g258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4" name=""/>
              <p:cNvSpPr/>
              <p:nvPr/>
            </p:nvSpPr>
            <p:spPr>
              <a:xfrm>
                <a:off x="3033360" y="130752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154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5" name=""/>
              <p:cNvSpPr/>
              <p:nvPr/>
            </p:nvSpPr>
            <p:spPr>
              <a:xfrm>
                <a:off x="4048920" y="13521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186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>
                <a:off x="3959280" y="13971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02235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7" name=""/>
              <p:cNvSpPr/>
              <p:nvPr/>
            </p:nvSpPr>
            <p:spPr>
              <a:xfrm>
                <a:off x="3959280" y="14418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653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8" name=""/>
              <p:cNvSpPr/>
              <p:nvPr/>
            </p:nvSpPr>
            <p:spPr>
              <a:xfrm>
                <a:off x="3959280" y="14716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112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9" name=""/>
              <p:cNvSpPr/>
              <p:nvPr/>
            </p:nvSpPr>
            <p:spPr>
              <a:xfrm>
                <a:off x="3914280" y="15163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387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0" name=""/>
              <p:cNvSpPr/>
              <p:nvPr/>
            </p:nvSpPr>
            <p:spPr>
              <a:xfrm>
                <a:off x="4347360" y="15613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397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>
                <a:off x="4226760" y="16059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398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2" name=""/>
              <p:cNvSpPr/>
              <p:nvPr/>
            </p:nvSpPr>
            <p:spPr>
              <a:xfrm>
                <a:off x="4183200" y="16506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401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3" name=""/>
              <p:cNvSpPr/>
              <p:nvPr/>
            </p:nvSpPr>
            <p:spPr>
              <a:xfrm>
                <a:off x="4151880" y="16804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412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4" name=""/>
              <p:cNvSpPr/>
              <p:nvPr/>
            </p:nvSpPr>
            <p:spPr>
              <a:xfrm>
                <a:off x="3974040" y="17254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402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>
                <a:off x="3705480" y="17701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69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6" name=""/>
              <p:cNvSpPr/>
              <p:nvPr/>
            </p:nvSpPr>
            <p:spPr>
              <a:xfrm>
                <a:off x="3705480" y="18147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0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7" name=""/>
              <p:cNvSpPr/>
              <p:nvPr/>
            </p:nvSpPr>
            <p:spPr>
              <a:xfrm>
                <a:off x="3809880" y="18597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0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8" name=""/>
              <p:cNvSpPr/>
              <p:nvPr/>
            </p:nvSpPr>
            <p:spPr>
              <a:xfrm>
                <a:off x="3720240" y="18896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5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9" name=""/>
              <p:cNvSpPr/>
              <p:nvPr/>
            </p:nvSpPr>
            <p:spPr>
              <a:xfrm>
                <a:off x="3615840" y="19342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94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>
                <a:off x="3078720" y="19792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70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1" name=""/>
              <p:cNvSpPr/>
              <p:nvPr/>
            </p:nvSpPr>
            <p:spPr>
              <a:xfrm>
                <a:off x="2600640" y="20239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68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2" name=""/>
              <p:cNvSpPr/>
              <p:nvPr/>
            </p:nvSpPr>
            <p:spPr>
              <a:xfrm>
                <a:off x="2690280" y="20685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556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3" name=""/>
              <p:cNvSpPr/>
              <p:nvPr/>
            </p:nvSpPr>
            <p:spPr>
              <a:xfrm>
                <a:off x="2854440" y="20984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588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4" name=""/>
              <p:cNvSpPr/>
              <p:nvPr/>
            </p:nvSpPr>
            <p:spPr>
              <a:xfrm>
                <a:off x="3466800" y="21434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598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5" name=""/>
              <p:cNvSpPr/>
              <p:nvPr/>
            </p:nvSpPr>
            <p:spPr>
              <a:xfrm>
                <a:off x="3541320" y="21880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600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6" name=""/>
              <p:cNvSpPr/>
              <p:nvPr/>
            </p:nvSpPr>
            <p:spPr>
              <a:xfrm>
                <a:off x="2589840" y="22327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237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7" name=""/>
              <p:cNvSpPr/>
              <p:nvPr/>
            </p:nvSpPr>
            <p:spPr>
              <a:xfrm>
                <a:off x="2709360" y="22777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237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8" name=""/>
              <p:cNvSpPr/>
              <p:nvPr/>
            </p:nvSpPr>
            <p:spPr>
              <a:xfrm>
                <a:off x="1902600" y="2322360"/>
                <a:ext cx="26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22540_SVP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9" name=""/>
              <p:cNvSpPr/>
              <p:nvPr/>
            </p:nvSpPr>
            <p:spPr>
              <a:xfrm>
                <a:off x="2051640" y="2352240"/>
                <a:ext cx="3207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333399"/>
                    </a:solidFill>
                    <a:latin typeface="Times New Roman"/>
                  </a:rPr>
                  <a:t>At4g24540_AGL2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0" name=""/>
              <p:cNvSpPr/>
              <p:nvPr/>
            </p:nvSpPr>
            <p:spPr>
              <a:xfrm>
                <a:off x="2142000" y="23968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2g523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1" name=""/>
              <p:cNvSpPr/>
              <p:nvPr/>
            </p:nvSpPr>
            <p:spPr>
              <a:xfrm>
                <a:off x="2124360" y="24418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582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2" name=""/>
              <p:cNvSpPr/>
              <p:nvPr/>
            </p:nvSpPr>
            <p:spPr>
              <a:xfrm>
                <a:off x="2201760" y="24865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6g113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3" name=""/>
              <p:cNvSpPr/>
              <p:nvPr/>
            </p:nvSpPr>
            <p:spPr>
              <a:xfrm>
                <a:off x="2212560" y="253116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458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4" name=""/>
              <p:cNvSpPr/>
              <p:nvPr/>
            </p:nvSpPr>
            <p:spPr>
              <a:xfrm>
                <a:off x="2097360" y="25610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0875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5" name=""/>
              <p:cNvSpPr/>
              <p:nvPr/>
            </p:nvSpPr>
            <p:spPr>
              <a:xfrm>
                <a:off x="2079720" y="260604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721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6" name=""/>
              <p:cNvSpPr/>
              <p:nvPr/>
            </p:nvSpPr>
            <p:spPr>
              <a:xfrm>
                <a:off x="1899360" y="26506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142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7" name=""/>
              <p:cNvSpPr/>
              <p:nvPr/>
            </p:nvSpPr>
            <p:spPr>
              <a:xfrm>
                <a:off x="2212560" y="26956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226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8" name=""/>
              <p:cNvSpPr/>
              <p:nvPr/>
            </p:nvSpPr>
            <p:spPr>
              <a:xfrm>
                <a:off x="2018520" y="27403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379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9" name=""/>
              <p:cNvSpPr/>
              <p:nvPr/>
            </p:nvSpPr>
            <p:spPr>
              <a:xfrm>
                <a:off x="1973880" y="27702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572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0" name=""/>
              <p:cNvSpPr/>
              <p:nvPr/>
            </p:nvSpPr>
            <p:spPr>
              <a:xfrm>
                <a:off x="2186640" y="28148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4g239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>
                <a:off x="2112120" y="28598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2g3692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2" name=""/>
              <p:cNvSpPr/>
              <p:nvPr/>
            </p:nvSpPr>
            <p:spPr>
              <a:xfrm>
                <a:off x="2108160" y="29044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469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3" name=""/>
              <p:cNvSpPr/>
              <p:nvPr/>
            </p:nvSpPr>
            <p:spPr>
              <a:xfrm>
                <a:off x="2112120" y="29491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4g387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4" name=""/>
              <p:cNvSpPr/>
              <p:nvPr/>
            </p:nvSpPr>
            <p:spPr>
              <a:xfrm>
                <a:off x="2079720" y="297900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5g124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>
                <a:off x="1947960" y="30240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2g498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6" name=""/>
              <p:cNvSpPr/>
              <p:nvPr/>
            </p:nvSpPr>
            <p:spPr>
              <a:xfrm>
                <a:off x="2033640" y="306864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570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7" name=""/>
              <p:cNvSpPr/>
              <p:nvPr/>
            </p:nvSpPr>
            <p:spPr>
              <a:xfrm>
                <a:off x="2544840" y="31132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6g239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8" name=""/>
              <p:cNvSpPr/>
              <p:nvPr/>
            </p:nvSpPr>
            <p:spPr>
              <a:xfrm>
                <a:off x="1858320" y="31582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8g33488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9" name=""/>
              <p:cNvSpPr/>
              <p:nvPr/>
            </p:nvSpPr>
            <p:spPr>
              <a:xfrm>
                <a:off x="2063520" y="31881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242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2093040" y="32328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158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1" name=""/>
              <p:cNvSpPr/>
              <p:nvPr/>
            </p:nvSpPr>
            <p:spPr>
              <a:xfrm>
                <a:off x="2138040" y="32774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023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2" name=""/>
              <p:cNvSpPr/>
              <p:nvPr/>
            </p:nvSpPr>
            <p:spPr>
              <a:xfrm>
                <a:off x="2142000" y="33224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8g419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3" name=""/>
              <p:cNvSpPr/>
              <p:nvPr/>
            </p:nvSpPr>
            <p:spPr>
              <a:xfrm>
                <a:off x="2138040" y="33670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412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>
                <a:off x="2127240" y="34124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9g32948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5" name=""/>
              <p:cNvSpPr/>
              <p:nvPr/>
            </p:nvSpPr>
            <p:spPr>
              <a:xfrm>
                <a:off x="2108160" y="344160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4g346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6" name=""/>
              <p:cNvSpPr/>
              <p:nvPr/>
            </p:nvSpPr>
            <p:spPr>
              <a:xfrm>
                <a:off x="2227680" y="34866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037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7" name=""/>
              <p:cNvSpPr/>
              <p:nvPr/>
            </p:nvSpPr>
            <p:spPr>
              <a:xfrm>
                <a:off x="2078280" y="35312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456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8" name=""/>
              <p:cNvSpPr/>
              <p:nvPr/>
            </p:nvSpPr>
            <p:spPr>
              <a:xfrm>
                <a:off x="2082240" y="35766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2g457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9" name=""/>
              <p:cNvSpPr/>
              <p:nvPr/>
            </p:nvSpPr>
            <p:spPr>
              <a:xfrm>
                <a:off x="2094480" y="36208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518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>
                <a:off x="2142000" y="365076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4g491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1" name=""/>
              <p:cNvSpPr/>
              <p:nvPr/>
            </p:nvSpPr>
            <p:spPr>
              <a:xfrm>
                <a:off x="2127240" y="36954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1161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2" name=""/>
              <p:cNvSpPr/>
              <p:nvPr/>
            </p:nvSpPr>
            <p:spPr>
              <a:xfrm>
                <a:off x="2138040" y="374076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698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3" name=""/>
              <p:cNvSpPr/>
              <p:nvPr/>
            </p:nvSpPr>
            <p:spPr>
              <a:xfrm>
                <a:off x="2082240" y="3785040"/>
                <a:ext cx="1821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6g067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>
                <a:off x="2094480" y="38296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485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5" name=""/>
              <p:cNvSpPr/>
              <p:nvPr/>
            </p:nvSpPr>
            <p:spPr>
              <a:xfrm>
                <a:off x="2246400" y="385956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541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6" name=""/>
              <p:cNvSpPr/>
              <p:nvPr/>
            </p:nvSpPr>
            <p:spPr>
              <a:xfrm>
                <a:off x="2243880" y="390492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083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2197800" y="39492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611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8" name=""/>
              <p:cNvSpPr/>
              <p:nvPr/>
            </p:nvSpPr>
            <p:spPr>
              <a:xfrm>
                <a:off x="2899080" y="39938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311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9" name=""/>
              <p:cNvSpPr/>
              <p:nvPr/>
            </p:nvSpPr>
            <p:spPr>
              <a:xfrm>
                <a:off x="2003760" y="40392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62165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0" name=""/>
              <p:cNvSpPr/>
              <p:nvPr/>
            </p:nvSpPr>
            <p:spPr>
              <a:xfrm>
                <a:off x="2032200" y="40690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2g428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1" name=""/>
              <p:cNvSpPr/>
              <p:nvPr/>
            </p:nvSpPr>
            <p:spPr>
              <a:xfrm>
                <a:off x="2032200" y="41133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587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2" name=""/>
              <p:cNvSpPr/>
              <p:nvPr/>
            </p:nvSpPr>
            <p:spPr>
              <a:xfrm>
                <a:off x="1957680" y="41580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189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3" name=""/>
              <p:cNvSpPr/>
              <p:nvPr/>
            </p:nvSpPr>
            <p:spPr>
              <a:xfrm>
                <a:off x="2574720" y="420336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5g113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>
                <a:off x="2004840" y="424764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2g063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5" name=""/>
              <p:cNvSpPr/>
              <p:nvPr/>
            </p:nvSpPr>
            <p:spPr>
              <a:xfrm>
                <a:off x="1974960" y="429300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2g329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6" name=""/>
              <p:cNvSpPr/>
              <p:nvPr/>
            </p:nvSpPr>
            <p:spPr>
              <a:xfrm>
                <a:off x="1992960" y="432216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5g1141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7" name=""/>
              <p:cNvSpPr/>
              <p:nvPr/>
            </p:nvSpPr>
            <p:spPr>
              <a:xfrm>
                <a:off x="1992960" y="43675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10504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2037600" y="44118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12g105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9" name=""/>
              <p:cNvSpPr/>
              <p:nvPr/>
            </p:nvSpPr>
            <p:spPr>
              <a:xfrm>
                <a:off x="1958760" y="445716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4g403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0" name=""/>
              <p:cNvSpPr/>
              <p:nvPr/>
            </p:nvSpPr>
            <p:spPr>
              <a:xfrm>
                <a:off x="1988640" y="450180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099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1" name=""/>
              <p:cNvSpPr/>
              <p:nvPr/>
            </p:nvSpPr>
            <p:spPr>
              <a:xfrm>
                <a:off x="2097360" y="45316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662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2" name=""/>
              <p:cNvSpPr/>
              <p:nvPr/>
            </p:nvSpPr>
            <p:spPr>
              <a:xfrm>
                <a:off x="1974960" y="457596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2g250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3" name=""/>
              <p:cNvSpPr/>
              <p:nvPr/>
            </p:nvSpPr>
            <p:spPr>
              <a:xfrm>
                <a:off x="2009160" y="4621320"/>
                <a:ext cx="2962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ff0000"/>
                    </a:solidFill>
                    <a:latin typeface="Times New Roman"/>
                  </a:rPr>
                  <a:t>At2g45660_SOC1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>
                <a:off x="2425680" y="466596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031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5" name=""/>
              <p:cNvSpPr/>
              <p:nvPr/>
            </p:nvSpPr>
            <p:spPr>
              <a:xfrm>
                <a:off x="1944000" y="47102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118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6" name=""/>
              <p:cNvSpPr/>
              <p:nvPr/>
            </p:nvSpPr>
            <p:spPr>
              <a:xfrm>
                <a:off x="1988640" y="47404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4g229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7" name=""/>
              <p:cNvSpPr/>
              <p:nvPr/>
            </p:nvSpPr>
            <p:spPr>
              <a:xfrm>
                <a:off x="2186640" y="47854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2g01355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2186640" y="48301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2g01365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9" name=""/>
              <p:cNvSpPr/>
              <p:nvPr/>
            </p:nvSpPr>
            <p:spPr>
              <a:xfrm>
                <a:off x="2634480" y="48744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6g018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0" name=""/>
              <p:cNvSpPr/>
              <p:nvPr/>
            </p:nvSpPr>
            <p:spPr>
              <a:xfrm>
                <a:off x="2378160" y="491976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007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1" name=""/>
              <p:cNvSpPr/>
              <p:nvPr/>
            </p:nvSpPr>
            <p:spPr>
              <a:xfrm>
                <a:off x="2037600" y="49496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10g3913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2" name=""/>
              <p:cNvSpPr/>
              <p:nvPr/>
            </p:nvSpPr>
            <p:spPr>
              <a:xfrm>
                <a:off x="1988640" y="49942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320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3" name=""/>
              <p:cNvSpPr/>
              <p:nvPr/>
            </p:nvSpPr>
            <p:spPr>
              <a:xfrm>
                <a:off x="2503080" y="5038920"/>
                <a:ext cx="375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009900"/>
                    </a:solidFill>
                    <a:latin typeface="Times New Roman"/>
                  </a:rPr>
                  <a:t>Os01g69850_MADS51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4" name=""/>
              <p:cNvSpPr/>
              <p:nvPr/>
            </p:nvSpPr>
            <p:spPr>
              <a:xfrm>
                <a:off x="2392920" y="508392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2g591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5" name=""/>
              <p:cNvSpPr/>
              <p:nvPr/>
            </p:nvSpPr>
            <p:spPr>
              <a:xfrm>
                <a:off x="2332080" y="512856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2g591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6" name=""/>
              <p:cNvSpPr/>
              <p:nvPr/>
            </p:nvSpPr>
            <p:spPr>
              <a:xfrm>
                <a:off x="2825640" y="515844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4g300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7" name=""/>
              <p:cNvSpPr/>
              <p:nvPr/>
            </p:nvSpPr>
            <p:spPr>
              <a:xfrm>
                <a:off x="2321280" y="52034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8g419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8" name=""/>
              <p:cNvSpPr/>
              <p:nvPr/>
            </p:nvSpPr>
            <p:spPr>
              <a:xfrm>
                <a:off x="2287440" y="52480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4130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9" name=""/>
              <p:cNvSpPr/>
              <p:nvPr/>
            </p:nvSpPr>
            <p:spPr>
              <a:xfrm>
                <a:off x="2228760" y="529272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770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0" name=""/>
              <p:cNvSpPr/>
              <p:nvPr/>
            </p:nvSpPr>
            <p:spPr>
              <a:xfrm>
                <a:off x="1957680" y="533772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137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1" name=""/>
              <p:cNvSpPr/>
              <p:nvPr/>
            </p:nvSpPr>
            <p:spPr>
              <a:xfrm>
                <a:off x="2078280" y="53823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518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2" name=""/>
              <p:cNvSpPr/>
              <p:nvPr/>
            </p:nvSpPr>
            <p:spPr>
              <a:xfrm>
                <a:off x="2093040" y="54122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518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3" name=""/>
              <p:cNvSpPr/>
              <p:nvPr/>
            </p:nvSpPr>
            <p:spPr>
              <a:xfrm>
                <a:off x="2152800" y="54568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2631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4" name=""/>
              <p:cNvSpPr/>
              <p:nvPr/>
            </p:nvSpPr>
            <p:spPr>
              <a:xfrm>
                <a:off x="2169720" y="5501880"/>
                <a:ext cx="266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69120_AP1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5" name=""/>
              <p:cNvSpPr/>
              <p:nvPr/>
            </p:nvSpPr>
            <p:spPr>
              <a:xfrm>
                <a:off x="2107440" y="5546520"/>
                <a:ext cx="26892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60910_FUL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6" name=""/>
              <p:cNvSpPr/>
              <p:nvPr/>
            </p:nvSpPr>
            <p:spPr>
              <a:xfrm>
                <a:off x="2227680" y="559116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302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7" name=""/>
              <p:cNvSpPr/>
              <p:nvPr/>
            </p:nvSpPr>
            <p:spPr>
              <a:xfrm>
                <a:off x="2067480" y="56210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3g541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8" name=""/>
              <p:cNvSpPr/>
              <p:nvPr/>
            </p:nvSpPr>
            <p:spPr>
              <a:xfrm>
                <a:off x="2055960" y="5666040"/>
                <a:ext cx="5187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300" spc="-1" strike="noStrike">
                    <a:solidFill>
                      <a:srgbClr val="333399"/>
                    </a:solidFill>
                    <a:latin typeface="Times New Roman"/>
                  </a:rPr>
                  <a:t>Bd1g08340_BdVRN1_BdFUL1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9" name=""/>
              <p:cNvSpPr/>
              <p:nvPr/>
            </p:nvSpPr>
            <p:spPr>
              <a:xfrm>
                <a:off x="2097360" y="57106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7g018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0" name=""/>
              <p:cNvSpPr/>
              <p:nvPr/>
            </p:nvSpPr>
            <p:spPr>
              <a:xfrm>
                <a:off x="2063520" y="575532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5925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1" name=""/>
              <p:cNvSpPr/>
              <p:nvPr/>
            </p:nvSpPr>
            <p:spPr>
              <a:xfrm>
                <a:off x="2052360" y="58003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7g413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2" name=""/>
              <p:cNvSpPr/>
              <p:nvPr/>
            </p:nvSpPr>
            <p:spPr>
              <a:xfrm>
                <a:off x="2108160" y="583020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1g219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3" name=""/>
              <p:cNvSpPr/>
              <p:nvPr/>
            </p:nvSpPr>
            <p:spPr>
              <a:xfrm>
                <a:off x="2604600" y="587484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12g31748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4" name=""/>
              <p:cNvSpPr/>
              <p:nvPr/>
            </p:nvSpPr>
            <p:spPr>
              <a:xfrm>
                <a:off x="2392920" y="591984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4g068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5" name=""/>
              <p:cNvSpPr/>
              <p:nvPr/>
            </p:nvSpPr>
            <p:spPr>
              <a:xfrm>
                <a:off x="2451240" y="596448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1g71692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6" name=""/>
              <p:cNvSpPr/>
              <p:nvPr/>
            </p:nvSpPr>
            <p:spPr>
              <a:xfrm>
                <a:off x="2485440" y="60091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8g020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7" name=""/>
              <p:cNvSpPr/>
              <p:nvPr/>
            </p:nvSpPr>
            <p:spPr>
              <a:xfrm>
                <a:off x="2436480" y="603900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3g135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8" name=""/>
              <p:cNvSpPr/>
              <p:nvPr/>
            </p:nvSpPr>
            <p:spPr>
              <a:xfrm>
                <a:off x="2664360" y="608400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12g1052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9" name=""/>
              <p:cNvSpPr/>
              <p:nvPr/>
            </p:nvSpPr>
            <p:spPr>
              <a:xfrm>
                <a:off x="2585880" y="612864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4g4036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0" name=""/>
              <p:cNvSpPr/>
              <p:nvPr/>
            </p:nvSpPr>
            <p:spPr>
              <a:xfrm>
                <a:off x="2602080" y="61732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4g409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1" name=""/>
              <p:cNvSpPr/>
              <p:nvPr/>
            </p:nvSpPr>
            <p:spPr>
              <a:xfrm>
                <a:off x="2646720" y="621828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5g1127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2" name=""/>
              <p:cNvSpPr/>
              <p:nvPr/>
            </p:nvSpPr>
            <p:spPr>
              <a:xfrm>
                <a:off x="2784240" y="626292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1g5268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3" name=""/>
              <p:cNvSpPr/>
              <p:nvPr/>
            </p:nvSpPr>
            <p:spPr>
              <a:xfrm>
                <a:off x="2855520" y="6292800"/>
                <a:ext cx="18504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Bd2g4869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4" name=""/>
              <p:cNvSpPr/>
              <p:nvPr/>
            </p:nvSpPr>
            <p:spPr>
              <a:xfrm>
                <a:off x="2376720" y="63374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3g543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5" name=""/>
              <p:cNvSpPr/>
              <p:nvPr/>
            </p:nvSpPr>
            <p:spPr>
              <a:xfrm>
                <a:off x="2615760" y="6382440"/>
                <a:ext cx="17748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At5g202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6" name=""/>
              <p:cNvSpPr/>
              <p:nvPr/>
            </p:nvSpPr>
            <p:spPr>
              <a:xfrm>
                <a:off x="2351160" y="6427080"/>
                <a:ext cx="201960" cy="46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300" spc="-1" strike="noStrike">
                    <a:solidFill>
                      <a:srgbClr val="000000"/>
                    </a:solidFill>
                    <a:latin typeface="Times New Roman"/>
                  </a:rPr>
                  <a:t>Os06g49840</a:t>
                </a:r>
                <a:endParaRPr b="0" lang="en-US" sz="3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47" name=""/>
            <p:cNvSpPr/>
            <p:nvPr/>
          </p:nvSpPr>
          <p:spPr>
            <a:xfrm>
              <a:off x="2436840" y="647208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350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>
              <a:off x="2157480" y="650196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1g660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>
              <a:off x="2426400" y="654732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5g349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>
              <a:off x="2467800" y="659160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2g249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>
              <a:off x="2153160" y="663696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2g570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>
              <a:off x="2500560" y="668160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2g074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2453040" y="671148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3g052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>
              <a:off x="2665080" y="675576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6g456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>
              <a:off x="2692080" y="680112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3221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>
              <a:off x="2123280" y="68457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3g5739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>
              <a:off x="2451600" y="68900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232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"/>
            <p:cNvSpPr/>
            <p:nvPr/>
          </p:nvSpPr>
          <p:spPr>
            <a:xfrm>
              <a:off x="2440800" y="692028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4g5241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"/>
            <p:cNvSpPr/>
            <p:nvPr/>
          </p:nvSpPr>
          <p:spPr>
            <a:xfrm>
              <a:off x="2362320" y="696528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5g217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"/>
            <p:cNvSpPr/>
            <p:nvPr/>
          </p:nvSpPr>
          <p:spPr>
            <a:xfrm>
              <a:off x="2424600" y="7009920"/>
              <a:ext cx="27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300" spc="-1" strike="noStrike">
                  <a:solidFill>
                    <a:srgbClr val="333399"/>
                  </a:solidFill>
                  <a:latin typeface="Times New Roman"/>
                </a:rPr>
                <a:t>At5g10140_FLC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"/>
            <p:cNvSpPr/>
            <p:nvPr/>
          </p:nvSpPr>
          <p:spPr>
            <a:xfrm>
              <a:off x="2571120" y="70545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650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"/>
            <p:cNvSpPr/>
            <p:nvPr/>
          </p:nvSpPr>
          <p:spPr>
            <a:xfrm>
              <a:off x="2571120" y="70995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650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"/>
            <p:cNvSpPr/>
            <p:nvPr/>
          </p:nvSpPr>
          <p:spPr>
            <a:xfrm>
              <a:off x="2541240" y="71294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6507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"/>
            <p:cNvSpPr/>
            <p:nvPr/>
          </p:nvSpPr>
          <p:spPr>
            <a:xfrm>
              <a:off x="2750760" y="71740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650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"/>
            <p:cNvSpPr/>
            <p:nvPr/>
          </p:nvSpPr>
          <p:spPr>
            <a:xfrm>
              <a:off x="2795400" y="72187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015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"/>
            <p:cNvSpPr/>
            <p:nvPr/>
          </p:nvSpPr>
          <p:spPr>
            <a:xfrm>
              <a:off x="3049200" y="72637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653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"/>
            <p:cNvSpPr/>
            <p:nvPr/>
          </p:nvSpPr>
          <p:spPr>
            <a:xfrm>
              <a:off x="2601000" y="73083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604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"/>
            <p:cNvSpPr/>
            <p:nvPr/>
          </p:nvSpPr>
          <p:spPr>
            <a:xfrm>
              <a:off x="2675520" y="73533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2g248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"/>
            <p:cNvSpPr/>
            <p:nvPr/>
          </p:nvSpPr>
          <p:spPr>
            <a:xfrm>
              <a:off x="2661120" y="73828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4g3659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"/>
            <p:cNvSpPr/>
            <p:nvPr/>
          </p:nvSpPr>
          <p:spPr>
            <a:xfrm>
              <a:off x="3795840" y="74278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46408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"/>
            <p:cNvSpPr/>
            <p:nvPr/>
          </p:nvSpPr>
          <p:spPr>
            <a:xfrm>
              <a:off x="3930120" y="74725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046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"/>
            <p:cNvSpPr/>
            <p:nvPr/>
          </p:nvSpPr>
          <p:spPr>
            <a:xfrm>
              <a:off x="4107960" y="75175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3862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"/>
            <p:cNvSpPr/>
            <p:nvPr/>
          </p:nvSpPr>
          <p:spPr>
            <a:xfrm>
              <a:off x="4107960" y="75621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4942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"/>
            <p:cNvSpPr/>
            <p:nvPr/>
          </p:nvSpPr>
          <p:spPr>
            <a:xfrm>
              <a:off x="4407840" y="75920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4949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"/>
            <p:cNvSpPr/>
            <p:nvPr/>
          </p:nvSpPr>
          <p:spPr>
            <a:xfrm>
              <a:off x="4064400" y="76366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608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"/>
            <p:cNvSpPr/>
            <p:nvPr/>
          </p:nvSpPr>
          <p:spPr>
            <a:xfrm>
              <a:off x="3870360" y="76816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6092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"/>
            <p:cNvSpPr/>
            <p:nvPr/>
          </p:nvSpPr>
          <p:spPr>
            <a:xfrm>
              <a:off x="4452480" y="77263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481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"/>
            <p:cNvSpPr/>
            <p:nvPr/>
          </p:nvSpPr>
          <p:spPr>
            <a:xfrm>
              <a:off x="4243320" y="77709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5g271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"/>
            <p:cNvSpPr/>
            <p:nvPr/>
          </p:nvSpPr>
          <p:spPr>
            <a:xfrm>
              <a:off x="3127680" y="780084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5g237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"/>
            <p:cNvSpPr/>
            <p:nvPr/>
          </p:nvSpPr>
          <p:spPr>
            <a:xfrm>
              <a:off x="2575080" y="784584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1g744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"/>
            <p:cNvSpPr/>
            <p:nvPr/>
          </p:nvSpPr>
          <p:spPr>
            <a:xfrm>
              <a:off x="3963960" y="789048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9g027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"/>
            <p:cNvSpPr/>
            <p:nvPr/>
          </p:nvSpPr>
          <p:spPr>
            <a:xfrm>
              <a:off x="2515680" y="793512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9g028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"/>
            <p:cNvSpPr/>
            <p:nvPr/>
          </p:nvSpPr>
          <p:spPr>
            <a:xfrm>
              <a:off x="3232440" y="798012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6g227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"/>
            <p:cNvSpPr/>
            <p:nvPr/>
          </p:nvSpPr>
          <p:spPr>
            <a:xfrm>
              <a:off x="2586600" y="801000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4g3942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"/>
            <p:cNvSpPr/>
            <p:nvPr/>
          </p:nvSpPr>
          <p:spPr>
            <a:xfrm>
              <a:off x="2751840" y="805464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2009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"/>
            <p:cNvSpPr/>
            <p:nvPr/>
          </p:nvSpPr>
          <p:spPr>
            <a:xfrm>
              <a:off x="2739600" y="809928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2g068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"/>
            <p:cNvSpPr/>
            <p:nvPr/>
          </p:nvSpPr>
          <p:spPr>
            <a:xfrm>
              <a:off x="2826360" y="814428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3g1867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"/>
            <p:cNvSpPr/>
            <p:nvPr/>
          </p:nvSpPr>
          <p:spPr>
            <a:xfrm>
              <a:off x="2602440" y="818892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2g2632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"/>
            <p:cNvSpPr/>
            <p:nvPr/>
          </p:nvSpPr>
          <p:spPr>
            <a:xfrm>
              <a:off x="4695120" y="823392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1g1151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"/>
            <p:cNvSpPr/>
            <p:nvPr/>
          </p:nvSpPr>
          <p:spPr>
            <a:xfrm>
              <a:off x="4366800" y="826344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7g0417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"/>
            <p:cNvSpPr/>
            <p:nvPr/>
          </p:nvSpPr>
          <p:spPr>
            <a:xfrm>
              <a:off x="4288320" y="830844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5741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"/>
            <p:cNvSpPr/>
            <p:nvPr/>
          </p:nvSpPr>
          <p:spPr>
            <a:xfrm>
              <a:off x="5243760" y="835308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5742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"/>
            <p:cNvSpPr/>
            <p:nvPr/>
          </p:nvSpPr>
          <p:spPr>
            <a:xfrm>
              <a:off x="4960080" y="839844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581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"/>
            <p:cNvSpPr/>
            <p:nvPr/>
          </p:nvSpPr>
          <p:spPr>
            <a:xfrm>
              <a:off x="4573080" y="844272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5787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"/>
            <p:cNvSpPr/>
            <p:nvPr/>
          </p:nvSpPr>
          <p:spPr>
            <a:xfrm>
              <a:off x="2485800" y="847260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6g3081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"/>
            <p:cNvSpPr/>
            <p:nvPr/>
          </p:nvSpPr>
          <p:spPr>
            <a:xfrm>
              <a:off x="3112920" y="851724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6g308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"/>
            <p:cNvSpPr/>
            <p:nvPr/>
          </p:nvSpPr>
          <p:spPr>
            <a:xfrm>
              <a:off x="2903760" y="856260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12g218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"/>
            <p:cNvSpPr/>
            <p:nvPr/>
          </p:nvSpPr>
          <p:spPr>
            <a:xfrm>
              <a:off x="3605400" y="860688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12g218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"/>
            <p:cNvSpPr/>
            <p:nvPr/>
          </p:nvSpPr>
          <p:spPr>
            <a:xfrm>
              <a:off x="3287880" y="865152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2g305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"/>
            <p:cNvSpPr/>
            <p:nvPr/>
          </p:nvSpPr>
          <p:spPr>
            <a:xfrm>
              <a:off x="2975760" y="868140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2g4329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"/>
            <p:cNvSpPr/>
            <p:nvPr/>
          </p:nvSpPr>
          <p:spPr>
            <a:xfrm>
              <a:off x="2676960" y="872676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1g279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"/>
            <p:cNvSpPr/>
            <p:nvPr/>
          </p:nvSpPr>
          <p:spPr>
            <a:xfrm>
              <a:off x="2616480" y="87710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1731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"/>
            <p:cNvSpPr/>
            <p:nvPr/>
          </p:nvSpPr>
          <p:spPr>
            <a:xfrm>
              <a:off x="2541240" y="88156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723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"/>
            <p:cNvSpPr/>
            <p:nvPr/>
          </p:nvSpPr>
          <p:spPr>
            <a:xfrm>
              <a:off x="3555360" y="88610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284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"/>
            <p:cNvSpPr/>
            <p:nvPr/>
          </p:nvSpPr>
          <p:spPr>
            <a:xfrm>
              <a:off x="3256920" y="88909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284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"/>
            <p:cNvSpPr/>
            <p:nvPr/>
          </p:nvSpPr>
          <p:spPr>
            <a:xfrm>
              <a:off x="3198240" y="893520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29962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"/>
            <p:cNvSpPr/>
            <p:nvPr/>
          </p:nvSpPr>
          <p:spPr>
            <a:xfrm>
              <a:off x="3855600" y="89798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547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"/>
            <p:cNvSpPr/>
            <p:nvPr/>
          </p:nvSpPr>
          <p:spPr>
            <a:xfrm>
              <a:off x="2810160" y="902520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3g048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"/>
            <p:cNvSpPr/>
            <p:nvPr/>
          </p:nvSpPr>
          <p:spPr>
            <a:xfrm>
              <a:off x="2750760" y="906948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2g344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"/>
            <p:cNvSpPr/>
            <p:nvPr/>
          </p:nvSpPr>
          <p:spPr>
            <a:xfrm>
              <a:off x="2735640" y="91148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3g66656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"/>
            <p:cNvSpPr/>
            <p:nvPr/>
          </p:nvSpPr>
          <p:spPr>
            <a:xfrm>
              <a:off x="2750760" y="91447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187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"/>
            <p:cNvSpPr/>
            <p:nvPr/>
          </p:nvSpPr>
          <p:spPr>
            <a:xfrm>
              <a:off x="3198240" y="91893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695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"/>
            <p:cNvSpPr/>
            <p:nvPr/>
          </p:nvSpPr>
          <p:spPr>
            <a:xfrm>
              <a:off x="3467160" y="923364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2g0306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"/>
            <p:cNvSpPr/>
            <p:nvPr/>
          </p:nvSpPr>
          <p:spPr>
            <a:xfrm>
              <a:off x="3023280" y="927900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11g4374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"/>
            <p:cNvSpPr/>
            <p:nvPr/>
          </p:nvSpPr>
          <p:spPr>
            <a:xfrm>
              <a:off x="2990880" y="932364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4g1110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"/>
            <p:cNvSpPr/>
            <p:nvPr/>
          </p:nvSpPr>
          <p:spPr>
            <a:xfrm>
              <a:off x="2108520" y="935352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2213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"/>
            <p:cNvSpPr/>
            <p:nvPr/>
          </p:nvSpPr>
          <p:spPr>
            <a:xfrm>
              <a:off x="2123280" y="93981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779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"/>
            <p:cNvSpPr/>
            <p:nvPr/>
          </p:nvSpPr>
          <p:spPr>
            <a:xfrm>
              <a:off x="2436840" y="9443160"/>
              <a:ext cx="17748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At1g7795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"/>
            <p:cNvSpPr/>
            <p:nvPr/>
          </p:nvSpPr>
          <p:spPr>
            <a:xfrm>
              <a:off x="2216880" y="948780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6g1197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"/>
            <p:cNvSpPr/>
            <p:nvPr/>
          </p:nvSpPr>
          <p:spPr>
            <a:xfrm>
              <a:off x="2097720" y="9532440"/>
              <a:ext cx="20196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Os08g3859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"/>
            <p:cNvSpPr/>
            <p:nvPr/>
          </p:nvSpPr>
          <p:spPr>
            <a:xfrm>
              <a:off x="2228040" y="9562320"/>
              <a:ext cx="185040" cy="46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300" spc="-1" strike="noStrike">
                  <a:solidFill>
                    <a:srgbClr val="000000"/>
                  </a:solidFill>
                  <a:latin typeface="Times New Roman"/>
                </a:rPr>
                <a:t>Bd3g39180</a:t>
              </a:r>
              <a:endParaRPr b="0" lang="en-US" sz="3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22" name=""/>
          <p:cNvSpPr/>
          <p:nvPr/>
        </p:nvSpPr>
        <p:spPr>
          <a:xfrm>
            <a:off x="3284640" y="4770360"/>
            <a:ext cx="203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SOC1 and MADS51 clades selected for tree in figure 9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3" name=""/>
          <p:cNvSpPr/>
          <p:nvPr/>
        </p:nvSpPr>
        <p:spPr>
          <a:xfrm>
            <a:off x="2600280" y="2289240"/>
            <a:ext cx="165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SVP clade selected for tree in figure 13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4" name=""/>
          <p:cNvSpPr/>
          <p:nvPr/>
        </p:nvSpPr>
        <p:spPr>
          <a:xfrm>
            <a:off x="2252160" y="918360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5" name=""/>
          <p:cNvSpPr/>
          <p:nvPr/>
        </p:nvSpPr>
        <p:spPr>
          <a:xfrm>
            <a:off x="2994120" y="6858000"/>
            <a:ext cx="1440" cy="322200"/>
          </a:xfrm>
          <a:custGeom>
            <a:avLst/>
            <a:gdLst/>
            <a:ahLst/>
            <a:rect l="l" t="t" r="r" b="b"/>
            <a:pathLst>
              <a:path w="1" h="203">
                <a:moveTo>
                  <a:pt x="1" y="0"/>
                </a:moveTo>
                <a:lnTo>
                  <a:pt x="0" y="20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6" name=""/>
          <p:cNvSpPr/>
          <p:nvPr/>
        </p:nvSpPr>
        <p:spPr>
          <a:xfrm>
            <a:off x="3284640" y="682452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FLC  / MAF clade selected for tree in Figure 13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7" name=""/>
          <p:cNvSpPr/>
          <p:nvPr/>
        </p:nvSpPr>
        <p:spPr>
          <a:xfrm>
            <a:off x="2924280" y="5600880"/>
            <a:ext cx="19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AP1/FULVRN1 clade selected for tree in figure 10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8" name=""/>
          <p:cNvSpPr/>
          <p:nvPr/>
        </p:nvSpPr>
        <p:spPr>
          <a:xfrm>
            <a:off x="1910520" y="240984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9" name=""/>
          <p:cNvSpPr/>
          <p:nvPr/>
        </p:nvSpPr>
        <p:spPr>
          <a:xfrm>
            <a:off x="1850400" y="252900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0" name=""/>
          <p:cNvSpPr/>
          <p:nvPr/>
        </p:nvSpPr>
        <p:spPr>
          <a:xfrm>
            <a:off x="1850040" y="602280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8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1" name=""/>
          <p:cNvSpPr/>
          <p:nvPr/>
        </p:nvSpPr>
        <p:spPr>
          <a:xfrm>
            <a:off x="4724280" y="344520"/>
            <a:ext cx="1656000" cy="147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0 datase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2" name=""/>
          <p:cNvSpPr/>
          <p:nvPr/>
        </p:nvSpPr>
        <p:spPr>
          <a:xfrm>
            <a:off x="2982240" y="885492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3" name=""/>
          <p:cNvSpPr/>
          <p:nvPr/>
        </p:nvSpPr>
        <p:spPr>
          <a:xfrm>
            <a:off x="3819960" y="751212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4" name=""/>
          <p:cNvSpPr/>
          <p:nvPr/>
        </p:nvSpPr>
        <p:spPr>
          <a:xfrm>
            <a:off x="3895200" y="769320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5" name=""/>
          <p:cNvSpPr/>
          <p:nvPr/>
        </p:nvSpPr>
        <p:spPr>
          <a:xfrm>
            <a:off x="3251880" y="825516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6" name=""/>
          <p:cNvSpPr/>
          <p:nvPr/>
        </p:nvSpPr>
        <p:spPr>
          <a:xfrm>
            <a:off x="2924280" y="685800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7" name=""/>
          <p:cNvSpPr/>
          <p:nvPr/>
        </p:nvSpPr>
        <p:spPr>
          <a:xfrm>
            <a:off x="2924280" y="718488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8" name=""/>
          <p:cNvSpPr/>
          <p:nvPr/>
        </p:nvSpPr>
        <p:spPr>
          <a:xfrm>
            <a:off x="2847960" y="5457960"/>
            <a:ext cx="6480" cy="498240"/>
          </a:xfrm>
          <a:custGeom>
            <a:avLst/>
            <a:gdLst/>
            <a:ahLst/>
            <a:rect l="l" t="t" r="r" b="b"/>
            <a:pathLst>
              <a:path w="4" h="314">
                <a:moveTo>
                  <a:pt x="4" y="0"/>
                </a:moveTo>
                <a:lnTo>
                  <a:pt x="0" y="314"/>
                </a:lnTo>
                <a:lnTo>
                  <a:pt x="3" y="20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9" name=""/>
          <p:cNvSpPr/>
          <p:nvPr/>
        </p:nvSpPr>
        <p:spPr>
          <a:xfrm>
            <a:off x="2781360" y="545796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0" name=""/>
          <p:cNvSpPr/>
          <p:nvPr/>
        </p:nvSpPr>
        <p:spPr>
          <a:xfrm>
            <a:off x="2781360" y="596124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1" name=""/>
          <p:cNvSpPr/>
          <p:nvPr/>
        </p:nvSpPr>
        <p:spPr>
          <a:xfrm>
            <a:off x="3137040" y="4622760"/>
            <a:ext cx="2880" cy="695520"/>
          </a:xfrm>
          <a:custGeom>
            <a:avLst/>
            <a:gdLst/>
            <a:ahLst/>
            <a:rect l="l" t="t" r="r" b="b"/>
            <a:pathLst>
              <a:path w="2" h="438">
                <a:moveTo>
                  <a:pt x="2" y="0"/>
                </a:moveTo>
                <a:lnTo>
                  <a:pt x="0" y="438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2" name=""/>
          <p:cNvSpPr/>
          <p:nvPr/>
        </p:nvSpPr>
        <p:spPr>
          <a:xfrm>
            <a:off x="3068640" y="462744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3" name=""/>
          <p:cNvSpPr/>
          <p:nvPr/>
        </p:nvSpPr>
        <p:spPr>
          <a:xfrm>
            <a:off x="3068640" y="531324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4" name=""/>
          <p:cNvSpPr/>
          <p:nvPr/>
        </p:nvSpPr>
        <p:spPr>
          <a:xfrm>
            <a:off x="2425680" y="2324160"/>
            <a:ext cx="3240" cy="326880"/>
          </a:xfrm>
          <a:custGeom>
            <a:avLst/>
            <a:gdLst/>
            <a:ahLst/>
            <a:rect l="l" t="t" r="r" b="b"/>
            <a:pathLst>
              <a:path w="2" h="206">
                <a:moveTo>
                  <a:pt x="0" y="0"/>
                </a:moveTo>
                <a:lnTo>
                  <a:pt x="0" y="206"/>
                </a:lnTo>
                <a:lnTo>
                  <a:pt x="2" y="20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5" name=""/>
          <p:cNvSpPr/>
          <p:nvPr/>
        </p:nvSpPr>
        <p:spPr>
          <a:xfrm>
            <a:off x="2349360" y="2324160"/>
            <a:ext cx="71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6" name=""/>
          <p:cNvSpPr/>
          <p:nvPr/>
        </p:nvSpPr>
        <p:spPr>
          <a:xfrm>
            <a:off x="2351160" y="265104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7" name=""/>
          <p:cNvSpPr/>
          <p:nvPr/>
        </p:nvSpPr>
        <p:spPr>
          <a:xfrm>
            <a:off x="2340720" y="702000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8" name=""/>
          <p:cNvSpPr/>
          <p:nvPr/>
        </p:nvSpPr>
        <p:spPr>
          <a:xfrm>
            <a:off x="2250720" y="918360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9" name=""/>
          <p:cNvSpPr/>
          <p:nvPr/>
        </p:nvSpPr>
        <p:spPr>
          <a:xfrm>
            <a:off x="1909080" y="240984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0" name=""/>
          <p:cNvSpPr/>
          <p:nvPr/>
        </p:nvSpPr>
        <p:spPr>
          <a:xfrm>
            <a:off x="1848960" y="252900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1" name=""/>
          <p:cNvSpPr/>
          <p:nvPr/>
        </p:nvSpPr>
        <p:spPr>
          <a:xfrm>
            <a:off x="1861200" y="935028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2" name=""/>
          <p:cNvSpPr/>
          <p:nvPr/>
        </p:nvSpPr>
        <p:spPr>
          <a:xfrm>
            <a:off x="1848600" y="602280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8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3" name=""/>
          <p:cNvSpPr/>
          <p:nvPr/>
        </p:nvSpPr>
        <p:spPr>
          <a:xfrm>
            <a:off x="2980800" y="885492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4" name=""/>
          <p:cNvSpPr/>
          <p:nvPr/>
        </p:nvSpPr>
        <p:spPr>
          <a:xfrm>
            <a:off x="3818520" y="751212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5" name=""/>
          <p:cNvSpPr/>
          <p:nvPr/>
        </p:nvSpPr>
        <p:spPr>
          <a:xfrm>
            <a:off x="3893760" y="769320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6" name=""/>
          <p:cNvSpPr/>
          <p:nvPr/>
        </p:nvSpPr>
        <p:spPr>
          <a:xfrm>
            <a:off x="3250440" y="825516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7" name=""/>
          <p:cNvSpPr/>
          <p:nvPr/>
        </p:nvSpPr>
        <p:spPr>
          <a:xfrm>
            <a:off x="1937520" y="703728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8" name=""/>
          <p:cNvSpPr/>
          <p:nvPr/>
        </p:nvSpPr>
        <p:spPr>
          <a:xfrm>
            <a:off x="2221920" y="664848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9" name=""/>
          <p:cNvSpPr/>
          <p:nvPr/>
        </p:nvSpPr>
        <p:spPr>
          <a:xfrm>
            <a:off x="2043720" y="689148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0" name=""/>
          <p:cNvSpPr/>
          <p:nvPr/>
        </p:nvSpPr>
        <p:spPr>
          <a:xfrm>
            <a:off x="1729800" y="636444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1" name=""/>
          <p:cNvSpPr/>
          <p:nvPr/>
        </p:nvSpPr>
        <p:spPr>
          <a:xfrm>
            <a:off x="1895040" y="404028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2" name=""/>
          <p:cNvSpPr/>
          <p:nvPr/>
        </p:nvSpPr>
        <p:spPr>
          <a:xfrm>
            <a:off x="1667520" y="442764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3" name=""/>
          <p:cNvSpPr/>
          <p:nvPr/>
        </p:nvSpPr>
        <p:spPr>
          <a:xfrm>
            <a:off x="2580840" y="621504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4" name=""/>
          <p:cNvSpPr/>
          <p:nvPr/>
        </p:nvSpPr>
        <p:spPr>
          <a:xfrm>
            <a:off x="2223720" y="597708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5" name=""/>
          <p:cNvSpPr/>
          <p:nvPr/>
        </p:nvSpPr>
        <p:spPr>
          <a:xfrm>
            <a:off x="2098080" y="3832200"/>
            <a:ext cx="22464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6" name=""/>
          <p:cNvSpPr/>
          <p:nvPr/>
        </p:nvSpPr>
        <p:spPr>
          <a:xfrm>
            <a:off x="1892880" y="371016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7" name=""/>
          <p:cNvSpPr/>
          <p:nvPr/>
        </p:nvSpPr>
        <p:spPr>
          <a:xfrm>
            <a:off x="2040480" y="475308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8" name=""/>
          <p:cNvSpPr/>
          <p:nvPr/>
        </p:nvSpPr>
        <p:spPr>
          <a:xfrm>
            <a:off x="1818360" y="266544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9" name=""/>
          <p:cNvSpPr/>
          <p:nvPr/>
        </p:nvSpPr>
        <p:spPr>
          <a:xfrm>
            <a:off x="1907280" y="290340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0" name=""/>
          <p:cNvSpPr/>
          <p:nvPr/>
        </p:nvSpPr>
        <p:spPr>
          <a:xfrm>
            <a:off x="1769040" y="299088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1" name=""/>
          <p:cNvSpPr/>
          <p:nvPr/>
        </p:nvSpPr>
        <p:spPr>
          <a:xfrm>
            <a:off x="1564200" y="932184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2" name=""/>
          <p:cNvSpPr/>
          <p:nvPr/>
        </p:nvSpPr>
        <p:spPr>
          <a:xfrm>
            <a:off x="2475360" y="181440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3" name=""/>
          <p:cNvSpPr/>
          <p:nvPr/>
        </p:nvSpPr>
        <p:spPr>
          <a:xfrm>
            <a:off x="2102400" y="203508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4" name=""/>
          <p:cNvSpPr/>
          <p:nvPr/>
        </p:nvSpPr>
        <p:spPr>
          <a:xfrm>
            <a:off x="3010320" y="118584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5" name=""/>
          <p:cNvSpPr/>
          <p:nvPr/>
        </p:nvSpPr>
        <p:spPr>
          <a:xfrm>
            <a:off x="2623320" y="73836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6" name=""/>
          <p:cNvSpPr/>
          <p:nvPr/>
        </p:nvSpPr>
        <p:spPr>
          <a:xfrm>
            <a:off x="3129840" y="2111400"/>
            <a:ext cx="22176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7" name=""/>
          <p:cNvSpPr/>
          <p:nvPr/>
        </p:nvSpPr>
        <p:spPr>
          <a:xfrm>
            <a:off x="1681560" y="219708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8" name=""/>
          <p:cNvSpPr/>
          <p:nvPr/>
        </p:nvSpPr>
        <p:spPr>
          <a:xfrm>
            <a:off x="2102400" y="873936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9" name=""/>
          <p:cNvSpPr/>
          <p:nvPr/>
        </p:nvSpPr>
        <p:spPr>
          <a:xfrm>
            <a:off x="2716920" y="852948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0" name=""/>
          <p:cNvSpPr/>
          <p:nvPr/>
        </p:nvSpPr>
        <p:spPr>
          <a:xfrm>
            <a:off x="2327760" y="9039240"/>
            <a:ext cx="208080" cy="12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1" name=""/>
          <p:cNvSpPr/>
          <p:nvPr/>
        </p:nvSpPr>
        <p:spPr>
          <a:xfrm>
            <a:off x="2424960" y="7186680"/>
            <a:ext cx="210960" cy="12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Arial"/>
              </a:rPr>
              <a:t>96</a:t>
            </a:r>
            <a:endParaRPr b="0" lang="en-US" sz="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4T10:31:54Z</dcterms:created>
  <dc:creator>baileyp</dc:creator>
  <dc:description/>
  <dc:language>en-US</dc:language>
  <cp:lastModifiedBy>Janet Higgins</cp:lastModifiedBy>
  <dcterms:modified xsi:type="dcterms:W3CDTF">2010-01-14T17:47:47Z</dcterms:modified>
  <cp:revision>19</cp:revision>
  <dc:subject/>
  <dc:title>Slide 1</dc:title>
</cp:coreProperties>
</file>